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80" r:id="rId3"/>
    <p:sldId id="278" r:id="rId4"/>
    <p:sldId id="268" r:id="rId5"/>
    <p:sldId id="269" r:id="rId6"/>
    <p:sldId id="271" r:id="rId7"/>
    <p:sldId id="276" r:id="rId8"/>
    <p:sldId id="282" r:id="rId9"/>
    <p:sldId id="281" r:id="rId10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B9235D9-5C40-4D95-BB6D-8A15FDB42082}" v="1" dt="2023-10-25T10:10:19.0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annis Gkekas" userId="4129b096333a1907" providerId="LiveId" clId="{4B9235D9-5C40-4D95-BB6D-8A15FDB42082}"/>
    <pc:docChg chg="custSel addSld delSld modSld">
      <pc:chgData name="Giannis Gkekas" userId="4129b096333a1907" providerId="LiveId" clId="{4B9235D9-5C40-4D95-BB6D-8A15FDB42082}" dt="2023-10-25T10:10:24.596" v="3" actId="2696"/>
      <pc:docMkLst>
        <pc:docMk/>
      </pc:docMkLst>
      <pc:sldChg chg="delSp new del mod modClrScheme chgLayout">
        <pc:chgData name="Giannis Gkekas" userId="4129b096333a1907" providerId="LiveId" clId="{4B9235D9-5C40-4D95-BB6D-8A15FDB42082}" dt="2023-10-25T10:10:24.596" v="3" actId="2696"/>
        <pc:sldMkLst>
          <pc:docMk/>
          <pc:sldMk cId="3966962902" sldId="256"/>
        </pc:sldMkLst>
        <pc:spChg chg="del">
          <ac:chgData name="Giannis Gkekas" userId="4129b096333a1907" providerId="LiveId" clId="{4B9235D9-5C40-4D95-BB6D-8A15FDB42082}" dt="2023-10-25T10:08:41.532" v="1" actId="700"/>
          <ac:spMkLst>
            <pc:docMk/>
            <pc:sldMk cId="3966962902" sldId="256"/>
            <ac:spMk id="2" creationId="{2EBA60B6-9836-E61C-8181-703AE0C73EF8}"/>
          </ac:spMkLst>
        </pc:spChg>
        <pc:spChg chg="del">
          <ac:chgData name="Giannis Gkekas" userId="4129b096333a1907" providerId="LiveId" clId="{4B9235D9-5C40-4D95-BB6D-8A15FDB42082}" dt="2023-10-25T10:08:41.532" v="1" actId="700"/>
          <ac:spMkLst>
            <pc:docMk/>
            <pc:sldMk cId="3966962902" sldId="256"/>
            <ac:spMk id="3" creationId="{374925EA-6855-0FFD-5525-350186F03E83}"/>
          </ac:spMkLst>
        </pc:spChg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2539580184" sldId="268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1036730276" sldId="269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3913324064" sldId="271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4102986614" sldId="276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211745979" sldId="277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344612016" sldId="278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1431265364" sldId="279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554133386" sldId="280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3023783349" sldId="281"/>
        </pc:sldMkLst>
      </pc:sldChg>
      <pc:sldChg chg="add">
        <pc:chgData name="Giannis Gkekas" userId="4129b096333a1907" providerId="LiveId" clId="{4B9235D9-5C40-4D95-BB6D-8A15FDB42082}" dt="2023-10-25T10:10:19.089" v="2"/>
        <pc:sldMkLst>
          <pc:docMk/>
          <pc:sldMk cId="2957010" sldId="28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70FC56E-D62B-D35F-AF94-7EC2E084A2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F0EA7031-D236-0A5D-9826-F46DF184ED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039A3DE-F861-A4D8-A41A-18D30B2CB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58CEEA01-72F1-6B91-D0E1-FC9E25737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2BD9816B-073F-4077-339A-097B54E2A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61273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E68222E-99DA-D979-0199-CC28CBD091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1F6C5A70-3363-EB9E-C333-D3AFA1A815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823D104-27A1-9B42-A6BA-C9CBA743F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79BF1835-B067-996F-11A3-50D7F1DD5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1CDE3703-72EB-D77D-CE95-0DF5B7A6A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83361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43824297-B61B-7DDF-13B4-5A2AE1EEB9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EEC4A67A-BDF1-F328-3CC7-C41C0F8BA2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ABF679E-EC55-C827-C77D-F3D4478FC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FDFB52F7-97CE-EE79-C7D1-0AD532383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4774975B-C42A-636E-4018-84C5717AD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638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44CDE2C-183C-ED19-BF2E-B5181C5F8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C31FF0F6-C118-251E-955D-2D5BC3C1CA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E3636151-9A53-2027-BF7C-76C5893FC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23047B08-A417-FCF9-C5F5-4954186A4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110477F8-0EB8-B4C5-A599-E2CFE917E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72797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EB6F46D2-FFF4-D900-20CC-171A1F4A7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9A1036EB-D83F-4F91-584E-332DED1C4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A6E85354-4793-1371-A3CF-E15872915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07FE27ED-1081-3C5E-3B27-97D7CB691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53DFE732-11DA-5CDE-64D1-D9D88F649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48730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E4D2C1AC-5E03-7D76-3DFF-B02E94AA3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13BE0A67-4405-DB62-345A-AA31B85EFE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7A5AA888-6947-9CA1-B325-959657EE5B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8750D72C-D816-83CE-9DF7-9B1FEF46A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E7F03FD3-8D75-C426-D85C-E8840A64D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7C7B3F2B-2726-DB86-41A0-5568F6853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42412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F3EBFAA3-BAB8-D09F-F981-39C020CE7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A190CA6A-37F8-9B4D-1CA2-2FB151FF52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F61ED08E-51E2-5237-F291-7B65C0E9EB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41C7C33E-5437-0C70-4517-01DC0C2215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8F6CF075-162D-3176-572F-12EB13C02D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2CB99F3F-5F2D-F0F2-F2E1-4EF54B634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2EF70CFB-DBEB-44A3-111F-575C9AAEE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E7B8167B-74C4-90D7-E250-E27B84D45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32597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EC3ACA24-C296-0E6E-7EA6-DD1E2FA6DA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320CBC10-5AD1-3DC0-E2DA-48A9ABC31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4491B446-08D8-8C0E-B051-7F956C0DB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697AD108-A079-C96F-C1AB-0314C6A80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6830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305E7EC6-954A-E8F1-725A-BAE707AF7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C3265ECF-A539-0CD1-EF4E-698B1A7CC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0218000A-EDD4-8CB5-C736-8AC7DC65B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53746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F64DCE6-4E7A-1285-C197-E9100E23B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91CF89D7-EB73-7E07-0E38-BAB50306E5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AA505CF6-3E91-4A54-3EBB-1A6AD2495E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265A7DD9-75DF-E8C0-D197-8F46AACCB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4C70768-5F5E-C5B0-31CE-7FA0C51E9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A65CF1E4-01C5-FDDD-7AC3-995403D59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08699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F8A633F0-AC72-D905-5E95-6EC9BCA9C9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CEB1EC16-A67F-3F79-F2EC-B1C37DCB02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4985FA29-4E4E-E42A-2559-8A2D23F26D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16F0A254-CF6C-E988-C215-ABBF82578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67FFDDA5-C76C-214A-5479-DB7D32AC6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942BBB01-D6FE-A5A3-EFD8-0E948E660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23955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ACE464B7-BB67-1132-1ADF-F2E245298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5DBF88E2-F31E-9C0D-CD69-CD4F3990A3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832E5961-E049-85BC-8170-FA4BE13168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0BDDA-373D-4643-B431-CAB88FAA77F1}" type="datetimeFigureOut">
              <a:rPr lang="el-GR" smtClean="0"/>
              <a:t>15/11/2023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D6855CE8-8B10-A773-61D0-9729AC025A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3979C8B1-838E-CFD1-7DCC-A62A1712C0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C9A08-1CFA-47CE-A4EA-A83DE45F4CF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44932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microsoft.com/office/2007/relationships/hdphoto" Target="../media/hdphoto5.wdp"/><Relationship Id="rId4" Type="http://schemas.openxmlformats.org/officeDocument/2006/relationships/image" Target="../media/image20.png"/><Relationship Id="rId9" Type="http://schemas.openxmlformats.org/officeDocument/2006/relationships/image" Target="../media/image2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AC2E010-A40A-21B7-61D3-CBD1FB7EEA87}"/>
              </a:ext>
            </a:extLst>
          </p:cNvPr>
          <p:cNvSpPr txBox="1"/>
          <p:nvPr/>
        </p:nvSpPr>
        <p:spPr>
          <a:xfrm>
            <a:off x="95607" y="-98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Ομάδα 28">
            <a:extLst>
              <a:ext uri="{FF2B5EF4-FFF2-40B4-BE49-F238E27FC236}">
                <a16:creationId xmlns:a16="http://schemas.microsoft.com/office/drawing/2014/main" id="{FBCE4701-669D-D40A-4572-EC468E082E08}"/>
              </a:ext>
            </a:extLst>
          </p:cNvPr>
          <p:cNvGrpSpPr/>
          <p:nvPr/>
        </p:nvGrpSpPr>
        <p:grpSpPr>
          <a:xfrm>
            <a:off x="3882033" y="910575"/>
            <a:ext cx="4378314" cy="3808603"/>
            <a:chOff x="5107527" y="732709"/>
            <a:chExt cx="4378314" cy="3808603"/>
          </a:xfrm>
        </p:grpSpPr>
        <p:pic>
          <p:nvPicPr>
            <p:cNvPr id="10" name="Εικόνα 9" descr="Εικόνα που περιέχει κείμενο, διάγραμμα, γράφημα, σχεδίαση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B203CB60-3DE7-4A84-5490-F6DEEAF4AD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63" t="6163" r="19006" b="34732"/>
            <a:stretch/>
          </p:blipFill>
          <p:spPr>
            <a:xfrm>
              <a:off x="5467351" y="901509"/>
              <a:ext cx="3295650" cy="306089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EFBF8FC-2412-7FF2-FFDF-3D06CECF4B53}"/>
                </a:ext>
              </a:extLst>
            </p:cNvPr>
            <p:cNvSpPr txBox="1"/>
            <p:nvPr/>
          </p:nvSpPr>
          <p:spPr>
            <a:xfrm>
              <a:off x="5854159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F797291-9F1E-A052-6AC8-98D5D8B6A5BA}"/>
                </a:ext>
              </a:extLst>
            </p:cNvPr>
            <p:cNvSpPr txBox="1"/>
            <p:nvPr/>
          </p:nvSpPr>
          <p:spPr>
            <a:xfrm>
              <a:off x="6339001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1407887-4913-C1EC-7482-34D4A1C5AC38}"/>
                </a:ext>
              </a:extLst>
            </p:cNvPr>
            <p:cNvSpPr txBox="1"/>
            <p:nvPr/>
          </p:nvSpPr>
          <p:spPr>
            <a:xfrm>
              <a:off x="6781286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7512989-8A8F-7F30-CBC5-DC860D8A4AD6}"/>
                </a:ext>
              </a:extLst>
            </p:cNvPr>
            <p:cNvSpPr txBox="1"/>
            <p:nvPr/>
          </p:nvSpPr>
          <p:spPr>
            <a:xfrm>
              <a:off x="7270270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D2347EE-7950-0C2C-E6BA-7DC5CA4B81B1}"/>
                </a:ext>
              </a:extLst>
            </p:cNvPr>
            <p:cNvSpPr txBox="1"/>
            <p:nvPr/>
          </p:nvSpPr>
          <p:spPr>
            <a:xfrm>
              <a:off x="7692039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36AA576-6E68-DDEA-9AFC-1D33045F2874}"/>
                </a:ext>
              </a:extLst>
            </p:cNvPr>
            <p:cNvSpPr txBox="1"/>
            <p:nvPr/>
          </p:nvSpPr>
          <p:spPr>
            <a:xfrm>
              <a:off x="8157722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l-GR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3268154-365E-A2A9-C40D-6C95F6F85F68}"/>
                </a:ext>
              </a:extLst>
            </p:cNvPr>
            <p:cNvSpPr txBox="1"/>
            <p:nvPr/>
          </p:nvSpPr>
          <p:spPr>
            <a:xfrm>
              <a:off x="5374831" y="3962400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l-GR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B64315B-372A-E7DB-1911-F54F083F4085}"/>
                </a:ext>
              </a:extLst>
            </p:cNvPr>
            <p:cNvSpPr txBox="1"/>
            <p:nvPr/>
          </p:nvSpPr>
          <p:spPr>
            <a:xfrm>
              <a:off x="5107527" y="2817865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77E308A-AC25-6D84-4A71-4524AA478C11}"/>
                </a:ext>
              </a:extLst>
            </p:cNvPr>
            <p:cNvSpPr txBox="1"/>
            <p:nvPr/>
          </p:nvSpPr>
          <p:spPr>
            <a:xfrm>
              <a:off x="5186074" y="37007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15F7383-F874-7A31-D47D-C9D2762D21D6}"/>
                </a:ext>
              </a:extLst>
            </p:cNvPr>
            <p:cNvSpPr txBox="1"/>
            <p:nvPr/>
          </p:nvSpPr>
          <p:spPr>
            <a:xfrm>
              <a:off x="5107527" y="101258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7F0214B-F5E2-DA2E-7761-FEC06EC83C24}"/>
                </a:ext>
              </a:extLst>
            </p:cNvPr>
            <p:cNvSpPr txBox="1"/>
            <p:nvPr/>
          </p:nvSpPr>
          <p:spPr>
            <a:xfrm>
              <a:off x="5107527" y="1916820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C78D54A-3764-DF41-646D-F604C7E878DF}"/>
                </a:ext>
              </a:extLst>
            </p:cNvPr>
            <p:cNvSpPr txBox="1"/>
            <p:nvPr/>
          </p:nvSpPr>
          <p:spPr>
            <a:xfrm>
              <a:off x="6788003" y="4233535"/>
              <a:ext cx="6543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YFP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Ορθογώνιο 22">
              <a:extLst>
                <a:ext uri="{FF2B5EF4-FFF2-40B4-BE49-F238E27FC236}">
                  <a16:creationId xmlns:a16="http://schemas.microsoft.com/office/drawing/2014/main" id="{96D1AB4F-B8C9-57E8-AE5C-6E87E46DB6EC}"/>
                </a:ext>
              </a:extLst>
            </p:cNvPr>
            <p:cNvSpPr/>
            <p:nvPr/>
          </p:nvSpPr>
          <p:spPr>
            <a:xfrm>
              <a:off x="8778252" y="810397"/>
              <a:ext cx="200025" cy="152400"/>
            </a:xfrm>
            <a:prstGeom prst="rect">
              <a:avLst/>
            </a:prstGeom>
            <a:solidFill>
              <a:schemeClr val="accent3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  <p:sp>
          <p:nvSpPr>
            <p:cNvPr id="24" name="Ορθογώνιο 23">
              <a:extLst>
                <a:ext uri="{FF2B5EF4-FFF2-40B4-BE49-F238E27FC236}">
                  <a16:creationId xmlns:a16="http://schemas.microsoft.com/office/drawing/2014/main" id="{85FF1034-7A46-5012-C965-7B07A5C30889}"/>
                </a:ext>
              </a:extLst>
            </p:cNvPr>
            <p:cNvSpPr/>
            <p:nvPr/>
          </p:nvSpPr>
          <p:spPr>
            <a:xfrm>
              <a:off x="8778253" y="1094658"/>
              <a:ext cx="200025" cy="152400"/>
            </a:xfrm>
            <a:prstGeom prst="rect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42BD475-6C89-2AD2-1D13-9AD3E0A1B944}"/>
                </a:ext>
              </a:extLst>
            </p:cNvPr>
            <p:cNvSpPr txBox="1"/>
            <p:nvPr/>
          </p:nvSpPr>
          <p:spPr>
            <a:xfrm>
              <a:off x="9053841" y="732709"/>
              <a:ext cx="43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25705F8-5B81-464A-5F1B-C0AE3B834BDF}"/>
                </a:ext>
              </a:extLst>
            </p:cNvPr>
            <p:cNvSpPr txBox="1"/>
            <p:nvPr/>
          </p:nvSpPr>
          <p:spPr>
            <a:xfrm>
              <a:off x="9053841" y="1016970"/>
              <a:ext cx="43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21C803F-ED27-5B33-FB49-D8E7603F275E}"/>
                </a:ext>
              </a:extLst>
            </p:cNvPr>
            <p:cNvSpPr txBox="1"/>
            <p:nvPr/>
          </p:nvSpPr>
          <p:spPr>
            <a:xfrm>
              <a:off x="7428519" y="1135691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8%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Αριστερή αγκύλη 27">
              <a:extLst>
                <a:ext uri="{FF2B5EF4-FFF2-40B4-BE49-F238E27FC236}">
                  <a16:creationId xmlns:a16="http://schemas.microsoft.com/office/drawing/2014/main" id="{173888DF-0E59-A768-46D5-EAE81628988C}"/>
                </a:ext>
              </a:extLst>
            </p:cNvPr>
            <p:cNvSpPr/>
            <p:nvPr/>
          </p:nvSpPr>
          <p:spPr>
            <a:xfrm rot="5400000">
              <a:off x="7601939" y="464366"/>
              <a:ext cx="144000" cy="1512000"/>
            </a:xfrm>
            <a:prstGeom prst="leftBracket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</p:grpSp>
      <p:grpSp>
        <p:nvGrpSpPr>
          <p:cNvPr id="31" name="Ομάδα 30">
            <a:extLst>
              <a:ext uri="{FF2B5EF4-FFF2-40B4-BE49-F238E27FC236}">
                <a16:creationId xmlns:a16="http://schemas.microsoft.com/office/drawing/2014/main" id="{FA5D3D24-6F7F-A6E2-4C2A-BA5A5A466C5C}"/>
              </a:ext>
            </a:extLst>
          </p:cNvPr>
          <p:cNvGrpSpPr/>
          <p:nvPr/>
        </p:nvGrpSpPr>
        <p:grpSpPr>
          <a:xfrm>
            <a:off x="472449" y="1494970"/>
            <a:ext cx="2638478" cy="2639813"/>
            <a:chOff x="740726" y="721101"/>
            <a:chExt cx="2638478" cy="2639813"/>
          </a:xfrm>
        </p:grpSpPr>
        <p:pic>
          <p:nvPicPr>
            <p:cNvPr id="4" name="Εικόνα 3" descr="Εικόνα που περιέχει πολυχρωμία, φως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9B0660B6-C12B-404E-FBE2-8D46FE7801BD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3" t="13165" r="4662"/>
            <a:stretch/>
          </p:blipFill>
          <p:spPr>
            <a:xfrm>
              <a:off x="740726" y="721101"/>
              <a:ext cx="2638478" cy="2639813"/>
            </a:xfrm>
            <a:prstGeom prst="rect">
              <a:avLst/>
            </a:prstGeom>
          </p:spPr>
        </p:pic>
        <p:cxnSp>
          <p:nvCxnSpPr>
            <p:cNvPr id="30" name="33 - Ευθεία γραμμή σύνδεσης">
              <a:extLst>
                <a:ext uri="{FF2B5EF4-FFF2-40B4-BE49-F238E27FC236}">
                  <a16:creationId xmlns:a16="http://schemas.microsoft.com/office/drawing/2014/main" id="{40C2A369-5459-7C74-656E-DD8133092902}"/>
                </a:ext>
              </a:extLst>
            </p:cNvPr>
            <p:cNvCxnSpPr/>
            <p:nvPr/>
          </p:nvCxnSpPr>
          <p:spPr>
            <a:xfrm>
              <a:off x="2937090" y="3161154"/>
              <a:ext cx="324000" cy="1588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3C4A409C-DC7D-3DB5-E263-D64A26C98EC1}"/>
              </a:ext>
            </a:extLst>
          </p:cNvPr>
          <p:cNvSpPr txBox="1"/>
          <p:nvPr/>
        </p:nvSpPr>
        <p:spPr>
          <a:xfrm>
            <a:off x="82898" y="8648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607E42F-EB52-38EB-05FE-C8EC6EF3F3E3}"/>
              </a:ext>
            </a:extLst>
          </p:cNvPr>
          <p:cNvSpPr txBox="1"/>
          <p:nvPr/>
        </p:nvSpPr>
        <p:spPr>
          <a:xfrm>
            <a:off x="3471514" y="8648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Ομάδα 38">
            <a:extLst>
              <a:ext uri="{FF2B5EF4-FFF2-40B4-BE49-F238E27FC236}">
                <a16:creationId xmlns:a16="http://schemas.microsoft.com/office/drawing/2014/main" id="{65B71ED7-0725-B395-FD4D-C15691F42CC4}"/>
              </a:ext>
            </a:extLst>
          </p:cNvPr>
          <p:cNvGrpSpPr/>
          <p:nvPr/>
        </p:nvGrpSpPr>
        <p:grpSpPr>
          <a:xfrm>
            <a:off x="8685245" y="881959"/>
            <a:ext cx="3485344" cy="3865834"/>
            <a:chOff x="8685245" y="718705"/>
            <a:chExt cx="3485344" cy="3865834"/>
          </a:xfrm>
        </p:grpSpPr>
        <p:pic>
          <p:nvPicPr>
            <p:cNvPr id="3" name="Εικόνα 2" descr="Εικόνα που περιέχει σκίτσο/σχέδιο, λευκό, κείμενο, ψυγείο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6107DEE0-21F7-BF24-5272-FF06CA1F92A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17533" y="1095283"/>
              <a:ext cx="1603852" cy="315758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6AD8F04-F56F-6E0F-9E0C-8A610EC750ED}"/>
                </a:ext>
              </a:extLst>
            </p:cNvPr>
            <p:cNvSpPr txBox="1"/>
            <p:nvPr/>
          </p:nvSpPr>
          <p:spPr>
            <a:xfrm rot="19062323">
              <a:off x="9961349" y="718705"/>
              <a:ext cx="397866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endParaRPr lang="el-GR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13B9DA8-ED8D-03F2-85CC-E42CB373F95A}"/>
                </a:ext>
              </a:extLst>
            </p:cNvPr>
            <p:cNvSpPr txBox="1"/>
            <p:nvPr/>
          </p:nvSpPr>
          <p:spPr>
            <a:xfrm rot="19062323">
              <a:off x="10753109" y="718705"/>
              <a:ext cx="397866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  <a:endParaRPr lang="el-GR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9B68D98-08E3-40A1-6EC3-6F2E0DC1DB04}"/>
                </a:ext>
              </a:extLst>
            </p:cNvPr>
            <p:cNvSpPr txBox="1"/>
            <p:nvPr/>
          </p:nvSpPr>
          <p:spPr>
            <a:xfrm>
              <a:off x="11423269" y="1293426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taxin-1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C289FF0-353D-FCB4-6C35-0D223D275911}"/>
                </a:ext>
              </a:extLst>
            </p:cNvPr>
            <p:cNvSpPr txBox="1"/>
            <p:nvPr/>
          </p:nvSpPr>
          <p:spPr>
            <a:xfrm>
              <a:off x="8685245" y="1293426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Ευθύγραμμο βέλος σύνδεσης 8">
              <a:extLst>
                <a:ext uri="{FF2B5EF4-FFF2-40B4-BE49-F238E27FC236}">
                  <a16:creationId xmlns:a16="http://schemas.microsoft.com/office/drawing/2014/main" id="{625246EF-5D43-78D5-3F3C-8F728607BB64}"/>
                </a:ext>
              </a:extLst>
            </p:cNvPr>
            <p:cNvCxnSpPr>
              <a:cxnSpLocks/>
            </p:cNvCxnSpPr>
            <p:nvPr/>
          </p:nvCxnSpPr>
          <p:spPr>
            <a:xfrm>
              <a:off x="9365741" y="1445242"/>
              <a:ext cx="21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Ευθύγραμμο βέλος σύνδεσης 33">
              <a:extLst>
                <a:ext uri="{FF2B5EF4-FFF2-40B4-BE49-F238E27FC236}">
                  <a16:creationId xmlns:a16="http://schemas.microsoft.com/office/drawing/2014/main" id="{B9BA5B34-2136-89AC-3CC5-C9AEC106C4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244333" y="1445242"/>
              <a:ext cx="21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DD3BD42-9B23-42CE-5130-3F0D018555EE}"/>
                </a:ext>
              </a:extLst>
            </p:cNvPr>
            <p:cNvSpPr txBox="1"/>
            <p:nvPr/>
          </p:nvSpPr>
          <p:spPr>
            <a:xfrm>
              <a:off x="8727724" y="3807290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Ευθύγραμμο βέλος σύνδεσης 35">
              <a:extLst>
                <a:ext uri="{FF2B5EF4-FFF2-40B4-BE49-F238E27FC236}">
                  <a16:creationId xmlns:a16="http://schemas.microsoft.com/office/drawing/2014/main" id="{06E13120-7C80-66CF-4591-BE9E74D79DEE}"/>
                </a:ext>
              </a:extLst>
            </p:cNvPr>
            <p:cNvCxnSpPr>
              <a:cxnSpLocks/>
            </p:cNvCxnSpPr>
            <p:nvPr/>
          </p:nvCxnSpPr>
          <p:spPr>
            <a:xfrm>
              <a:off x="9365741" y="3959106"/>
              <a:ext cx="21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3B09F61-C020-F385-347D-D818ECEAC6DD}"/>
                </a:ext>
              </a:extLst>
            </p:cNvPr>
            <p:cNvSpPr txBox="1"/>
            <p:nvPr/>
          </p:nvSpPr>
          <p:spPr>
            <a:xfrm>
              <a:off x="9992900" y="4292151"/>
              <a:ext cx="8531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anti-GFP</a:t>
              </a:r>
              <a:endParaRPr lang="el-GR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FD978700-1AFF-3CC5-5E4D-8B594BE388AB}"/>
              </a:ext>
            </a:extLst>
          </p:cNvPr>
          <p:cNvSpPr txBox="1"/>
          <p:nvPr/>
        </p:nvSpPr>
        <p:spPr>
          <a:xfrm>
            <a:off x="8552035" y="8648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1265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Εικόνα 2">
            <a:extLst>
              <a:ext uri="{FF2B5EF4-FFF2-40B4-BE49-F238E27FC236}">
                <a16:creationId xmlns:a16="http://schemas.microsoft.com/office/drawing/2014/main" id="{3EBAF01C-50A5-4225-4C75-5E461A0C75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8825" y="673443"/>
            <a:ext cx="2628900" cy="26289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D879D8E-59B3-7B83-467B-250E4D843D36}"/>
              </a:ext>
            </a:extLst>
          </p:cNvPr>
          <p:cNvSpPr txBox="1"/>
          <p:nvPr/>
        </p:nvSpPr>
        <p:spPr>
          <a:xfrm>
            <a:off x="1531685" y="2878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A6EC0E-F81E-1C4A-9339-0278B8E9FF32}"/>
              </a:ext>
            </a:extLst>
          </p:cNvPr>
          <p:cNvSpPr txBox="1"/>
          <p:nvPr/>
        </p:nvSpPr>
        <p:spPr>
          <a:xfrm>
            <a:off x="1531685" y="33661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Ομάδα 10">
            <a:extLst>
              <a:ext uri="{FF2B5EF4-FFF2-40B4-BE49-F238E27FC236}">
                <a16:creationId xmlns:a16="http://schemas.microsoft.com/office/drawing/2014/main" id="{4CB08567-AF0A-9F72-6F5C-B7580B90DA54}"/>
              </a:ext>
            </a:extLst>
          </p:cNvPr>
          <p:cNvGrpSpPr/>
          <p:nvPr/>
        </p:nvGrpSpPr>
        <p:grpSpPr>
          <a:xfrm>
            <a:off x="2029275" y="3746627"/>
            <a:ext cx="2628000" cy="2628000"/>
            <a:chOff x="5757289" y="816768"/>
            <a:chExt cx="2628000" cy="2628000"/>
          </a:xfrm>
        </p:grpSpPr>
        <p:pic>
          <p:nvPicPr>
            <p:cNvPr id="7" name="Εικόνα 6" descr="Εικόνα που περιέχει πράσινο, πολυχρωμία, φως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23F38AD2-CDC6-9B44-4C62-49181F2C81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57289" y="816768"/>
              <a:ext cx="2628000" cy="2628000"/>
            </a:xfrm>
            <a:prstGeom prst="rect">
              <a:avLst/>
            </a:prstGeom>
          </p:spPr>
        </p:pic>
        <p:cxnSp>
          <p:nvCxnSpPr>
            <p:cNvPr id="10" name="33 - Ευθεία γραμμή σύνδεσης">
              <a:extLst>
                <a:ext uri="{FF2B5EF4-FFF2-40B4-BE49-F238E27FC236}">
                  <a16:creationId xmlns:a16="http://schemas.microsoft.com/office/drawing/2014/main" id="{6BB84F5F-192F-46A6-BBE4-30EDB3CD527C}"/>
                </a:ext>
              </a:extLst>
            </p:cNvPr>
            <p:cNvCxnSpPr>
              <a:cxnSpLocks/>
            </p:cNvCxnSpPr>
            <p:nvPr/>
          </p:nvCxnSpPr>
          <p:spPr>
            <a:xfrm>
              <a:off x="8055841" y="3279744"/>
              <a:ext cx="252000" cy="1588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BA852133-28C1-3873-B830-2C4356292D6E}"/>
              </a:ext>
            </a:extLst>
          </p:cNvPr>
          <p:cNvSpPr txBox="1"/>
          <p:nvPr/>
        </p:nvSpPr>
        <p:spPr>
          <a:xfrm>
            <a:off x="6750566" y="1505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Ομάδα 20">
            <a:extLst>
              <a:ext uri="{FF2B5EF4-FFF2-40B4-BE49-F238E27FC236}">
                <a16:creationId xmlns:a16="http://schemas.microsoft.com/office/drawing/2014/main" id="{E1D5EC75-C918-D9A2-269F-4DD4A75B87B6}"/>
              </a:ext>
            </a:extLst>
          </p:cNvPr>
          <p:cNvGrpSpPr/>
          <p:nvPr/>
        </p:nvGrpSpPr>
        <p:grpSpPr>
          <a:xfrm>
            <a:off x="7464923" y="1070132"/>
            <a:ext cx="2980074" cy="4596710"/>
            <a:chOff x="7464923" y="1127282"/>
            <a:chExt cx="2980074" cy="459671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57A402D-8BA5-B53F-6442-90DF93D93875}"/>
                </a:ext>
              </a:extLst>
            </p:cNvPr>
            <p:cNvSpPr txBox="1"/>
            <p:nvPr/>
          </p:nvSpPr>
          <p:spPr>
            <a:xfrm rot="19579714">
              <a:off x="8410979" y="1127282"/>
              <a:ext cx="20340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YFP-ATXN1(Q82) (RA)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Εικόνα 14" descr="Εικόνα που περιέχει στιγμιότυπο οθόνης, λευκό, ορθογώνιο παραλληλόγραμμο, σχεδίαση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A25DA045-6372-2179-CD2A-FDE6153CF96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64923" y="1881579"/>
              <a:ext cx="2695679" cy="38424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E8094A9-751D-3603-928B-729895B1AF3F}"/>
                </a:ext>
              </a:extLst>
            </p:cNvPr>
            <p:cNvSpPr txBox="1"/>
            <p:nvPr/>
          </p:nvSpPr>
          <p:spPr>
            <a:xfrm rot="19579714">
              <a:off x="7562364" y="1224426"/>
              <a:ext cx="16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YFP-ATXN1(Q82)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F809070-DD29-A6E4-28EE-CA45082DFC61}"/>
                </a:ext>
              </a:extLst>
            </p:cNvPr>
            <p:cNvSpPr txBox="1"/>
            <p:nvPr/>
          </p:nvSpPr>
          <p:spPr>
            <a:xfrm rot="19579714">
              <a:off x="9500419" y="1482982"/>
              <a:ext cx="6829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5F6F2D8B-E9F8-DFB2-9AAE-C6D71D8B850E}"/>
              </a:ext>
            </a:extLst>
          </p:cNvPr>
          <p:cNvSpPr txBox="1"/>
          <p:nvPr/>
        </p:nvSpPr>
        <p:spPr>
          <a:xfrm>
            <a:off x="95607" y="-98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55BCB52-028A-2656-0B5C-7DE15E8CC157}"/>
              </a:ext>
            </a:extLst>
          </p:cNvPr>
          <p:cNvSpPr txBox="1"/>
          <p:nvPr/>
        </p:nvSpPr>
        <p:spPr>
          <a:xfrm>
            <a:off x="6663965" y="4622560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l-G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Ευθύγραμμο βέλος σύνδεσης 4">
            <a:extLst>
              <a:ext uri="{FF2B5EF4-FFF2-40B4-BE49-F238E27FC236}">
                <a16:creationId xmlns:a16="http://schemas.microsoft.com/office/drawing/2014/main" id="{2FD42F36-4057-344B-CBE4-4B142CDABF39}"/>
              </a:ext>
            </a:extLst>
          </p:cNvPr>
          <p:cNvCxnSpPr>
            <a:cxnSpLocks/>
          </p:cNvCxnSpPr>
          <p:nvPr/>
        </p:nvCxnSpPr>
        <p:spPr>
          <a:xfrm>
            <a:off x="7218817" y="4761059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92A2AF72-83EE-B00F-6FE9-AC21A9422101}"/>
              </a:ext>
            </a:extLst>
          </p:cNvPr>
          <p:cNvSpPr txBox="1"/>
          <p:nvPr/>
        </p:nvSpPr>
        <p:spPr>
          <a:xfrm>
            <a:off x="6579006" y="3549841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l-G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Ευθύγραμμο βέλος σύνδεσης 13">
            <a:extLst>
              <a:ext uri="{FF2B5EF4-FFF2-40B4-BE49-F238E27FC236}">
                <a16:creationId xmlns:a16="http://schemas.microsoft.com/office/drawing/2014/main" id="{DB1E22A7-F227-A10D-4730-A82A5913AF6B}"/>
              </a:ext>
            </a:extLst>
          </p:cNvPr>
          <p:cNvCxnSpPr>
            <a:cxnSpLocks/>
          </p:cNvCxnSpPr>
          <p:nvPr/>
        </p:nvCxnSpPr>
        <p:spPr>
          <a:xfrm>
            <a:off x="7218817" y="3688340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86FF2143-B35E-B1E5-E250-2517B5FC27C0}"/>
              </a:ext>
            </a:extLst>
          </p:cNvPr>
          <p:cNvSpPr txBox="1"/>
          <p:nvPr/>
        </p:nvSpPr>
        <p:spPr>
          <a:xfrm>
            <a:off x="6579006" y="294763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0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l-G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Ευθύγραμμο βέλος σύνδεσης 19">
            <a:extLst>
              <a:ext uri="{FF2B5EF4-FFF2-40B4-BE49-F238E27FC236}">
                <a16:creationId xmlns:a16="http://schemas.microsoft.com/office/drawing/2014/main" id="{7DA11EDF-D955-FD0E-C36A-C821455CFC2C}"/>
              </a:ext>
            </a:extLst>
          </p:cNvPr>
          <p:cNvCxnSpPr>
            <a:cxnSpLocks/>
          </p:cNvCxnSpPr>
          <p:nvPr/>
        </p:nvCxnSpPr>
        <p:spPr>
          <a:xfrm>
            <a:off x="7220295" y="3086137"/>
            <a:ext cx="216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Ευθεία γραμμή σύνδεσης 23">
            <a:extLst>
              <a:ext uri="{FF2B5EF4-FFF2-40B4-BE49-F238E27FC236}">
                <a16:creationId xmlns:a16="http://schemas.microsoft.com/office/drawing/2014/main" id="{0069A79D-AE68-73C4-BF83-F8ADA5138089}"/>
              </a:ext>
            </a:extLst>
          </p:cNvPr>
          <p:cNvCxnSpPr/>
          <p:nvPr/>
        </p:nvCxnSpPr>
        <p:spPr>
          <a:xfrm>
            <a:off x="4165583" y="3141132"/>
            <a:ext cx="432000" cy="0"/>
          </a:xfrm>
          <a:prstGeom prst="line">
            <a:avLst/>
          </a:prstGeom>
          <a:ln w="28575">
            <a:solidFill>
              <a:schemeClr val="bg2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4133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34DD8F60-7128-3DC1-38C8-26CF7B446D7E}"/>
              </a:ext>
            </a:extLst>
          </p:cNvPr>
          <p:cNvSpPr txBox="1"/>
          <p:nvPr/>
        </p:nvSpPr>
        <p:spPr>
          <a:xfrm>
            <a:off x="113050" y="3878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AA7E0E6-B20B-1DF9-6DE3-C2D56971D2A8}"/>
              </a:ext>
            </a:extLst>
          </p:cNvPr>
          <p:cNvSpPr txBox="1"/>
          <p:nvPr/>
        </p:nvSpPr>
        <p:spPr>
          <a:xfrm>
            <a:off x="6143698" y="3878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Εικόνα 22" descr="Εικόνα που περιέχει φως, πράσινο, πολυχρωμία&#10;&#10;Περιγραφή που δημιουργήθηκε αυτόματα">
            <a:extLst>
              <a:ext uri="{FF2B5EF4-FFF2-40B4-BE49-F238E27FC236}">
                <a16:creationId xmlns:a16="http://schemas.microsoft.com/office/drawing/2014/main" id="{814CE48C-D0D7-491D-6835-B1A2B4D6E6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7732" y="673551"/>
            <a:ext cx="2919984" cy="2919984"/>
          </a:xfrm>
          <a:prstGeom prst="rect">
            <a:avLst/>
          </a:prstGeom>
        </p:spPr>
      </p:pic>
      <p:grpSp>
        <p:nvGrpSpPr>
          <p:cNvPr id="51" name="Ομάδα 50">
            <a:extLst>
              <a:ext uri="{FF2B5EF4-FFF2-40B4-BE49-F238E27FC236}">
                <a16:creationId xmlns:a16="http://schemas.microsoft.com/office/drawing/2014/main" id="{00ACDA72-AA17-0442-637F-077E346F7341}"/>
              </a:ext>
            </a:extLst>
          </p:cNvPr>
          <p:cNvGrpSpPr/>
          <p:nvPr/>
        </p:nvGrpSpPr>
        <p:grpSpPr>
          <a:xfrm>
            <a:off x="6177681" y="399496"/>
            <a:ext cx="5949955" cy="3681167"/>
            <a:chOff x="6177681" y="257452"/>
            <a:chExt cx="5949955" cy="3681167"/>
          </a:xfrm>
        </p:grpSpPr>
        <p:grpSp>
          <p:nvGrpSpPr>
            <p:cNvPr id="46" name="Ομάδα 45">
              <a:extLst>
                <a:ext uri="{FF2B5EF4-FFF2-40B4-BE49-F238E27FC236}">
                  <a16:creationId xmlns:a16="http://schemas.microsoft.com/office/drawing/2014/main" id="{F9579898-87BF-9F7D-E71B-EE8C6EB6C0E0}"/>
                </a:ext>
              </a:extLst>
            </p:cNvPr>
            <p:cNvGrpSpPr/>
            <p:nvPr/>
          </p:nvGrpSpPr>
          <p:grpSpPr>
            <a:xfrm>
              <a:off x="6177681" y="257452"/>
              <a:ext cx="5949955" cy="3681167"/>
              <a:chOff x="6674832" y="257452"/>
              <a:chExt cx="5949955" cy="3681167"/>
            </a:xfrm>
          </p:grpSpPr>
          <p:pic>
            <p:nvPicPr>
              <p:cNvPr id="27" name="Εικόνα 26" descr="Εικόνα που περιέχει κείμενο, διάγραμμα, γράφημα, στιγμιότυπο οθόνης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B9F67458-3C79-BEB5-4E13-22BB9E1B0F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95" t="5680" r="14831" b="31875"/>
              <a:stretch/>
            </p:blipFill>
            <p:spPr>
              <a:xfrm>
                <a:off x="7424436" y="257452"/>
                <a:ext cx="3246524" cy="3135668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267B4F84-CF01-D685-A424-E0A7731E180F}"/>
                  </a:ext>
                </a:extLst>
              </p:cNvPr>
              <p:cNvSpPr txBox="1"/>
              <p:nvPr/>
            </p:nvSpPr>
            <p:spPr>
              <a:xfrm>
                <a:off x="7004127" y="2385888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31E5D47-3F99-C90C-F68E-B22254CB86D1}"/>
                  </a:ext>
                </a:extLst>
              </p:cNvPr>
              <p:cNvSpPr txBox="1"/>
              <p:nvPr/>
            </p:nvSpPr>
            <p:spPr>
              <a:xfrm>
                <a:off x="7082674" y="3144988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4C0E2B5-212D-06F2-227A-BFA0920BAE1E}"/>
                  </a:ext>
                </a:extLst>
              </p:cNvPr>
              <p:cNvSpPr txBox="1"/>
              <p:nvPr/>
            </p:nvSpPr>
            <p:spPr>
              <a:xfrm>
                <a:off x="7004127" y="92350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FAA5B93-86C4-DFFE-13C0-61CF5E1C8ED4}"/>
                  </a:ext>
                </a:extLst>
              </p:cNvPr>
              <p:cNvSpPr txBox="1"/>
              <p:nvPr/>
            </p:nvSpPr>
            <p:spPr>
              <a:xfrm>
                <a:off x="7004127" y="1646768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6902103-73BD-5C82-E1C1-418A5D8D7CC2}"/>
                  </a:ext>
                </a:extLst>
              </p:cNvPr>
              <p:cNvSpPr txBox="1"/>
              <p:nvPr/>
            </p:nvSpPr>
            <p:spPr>
              <a:xfrm>
                <a:off x="7741960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l-GR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B0B7BAD-3EEE-C67A-00F2-C1AE07A93AD0}"/>
                  </a:ext>
                </a:extLst>
              </p:cNvPr>
              <p:cNvSpPr txBox="1"/>
              <p:nvPr/>
            </p:nvSpPr>
            <p:spPr>
              <a:xfrm>
                <a:off x="8226802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l-GR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A243927E-5956-DB46-53C1-B63E0D5DFC57}"/>
                  </a:ext>
                </a:extLst>
              </p:cNvPr>
              <p:cNvSpPr txBox="1"/>
              <p:nvPr/>
            </p:nvSpPr>
            <p:spPr>
              <a:xfrm>
                <a:off x="8697662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l-GR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43954C2-A39A-7181-8BA2-61D40A70BA28}"/>
                  </a:ext>
                </a:extLst>
              </p:cNvPr>
              <p:cNvSpPr txBox="1"/>
              <p:nvPr/>
            </p:nvSpPr>
            <p:spPr>
              <a:xfrm>
                <a:off x="9167596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l-GR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1AF81FCC-E464-62D7-29E3-7FDA34345108}"/>
                  </a:ext>
                </a:extLst>
              </p:cNvPr>
              <p:cNvSpPr txBox="1"/>
              <p:nvPr/>
            </p:nvSpPr>
            <p:spPr>
              <a:xfrm>
                <a:off x="9627465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l-GR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CEAC90B4-B11B-8211-5465-A5E457B2FC27}"/>
                  </a:ext>
                </a:extLst>
              </p:cNvPr>
              <p:cNvSpPr txBox="1"/>
              <p:nvPr/>
            </p:nvSpPr>
            <p:spPr>
              <a:xfrm>
                <a:off x="10093148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D2F9BD9-12C7-F5C6-4BB4-403F4EFA0304}"/>
                  </a:ext>
                </a:extLst>
              </p:cNvPr>
              <p:cNvSpPr txBox="1"/>
              <p:nvPr/>
            </p:nvSpPr>
            <p:spPr>
              <a:xfrm>
                <a:off x="7310257" y="3357412"/>
                <a:ext cx="3946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1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l-GR" sz="11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157BBD6-E9C8-6168-F35C-EB5F3270312B}"/>
                  </a:ext>
                </a:extLst>
              </p:cNvPr>
              <p:cNvSpPr txBox="1"/>
              <p:nvPr/>
            </p:nvSpPr>
            <p:spPr>
              <a:xfrm rot="16200000">
                <a:off x="6452656" y="1671398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7F822B2-10EC-E721-2F3A-E722A9D10DBD}"/>
                  </a:ext>
                </a:extLst>
              </p:cNvPr>
              <p:cNvSpPr txBox="1"/>
              <p:nvPr/>
            </p:nvSpPr>
            <p:spPr>
              <a:xfrm>
                <a:off x="8771020" y="3630842"/>
                <a:ext cx="6829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Venus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Ορθογώνιο 41">
                <a:extLst>
                  <a:ext uri="{FF2B5EF4-FFF2-40B4-BE49-F238E27FC236}">
                    <a16:creationId xmlns:a16="http://schemas.microsoft.com/office/drawing/2014/main" id="{B5BB8D20-2E08-B31E-8D17-B64AE3ED26E4}"/>
                  </a:ext>
                </a:extLst>
              </p:cNvPr>
              <p:cNvSpPr/>
              <p:nvPr/>
            </p:nvSpPr>
            <p:spPr>
              <a:xfrm>
                <a:off x="10837198" y="396935"/>
                <a:ext cx="200025" cy="1524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43" name="Ορθογώνιο 42">
                <a:extLst>
                  <a:ext uri="{FF2B5EF4-FFF2-40B4-BE49-F238E27FC236}">
                    <a16:creationId xmlns:a16="http://schemas.microsoft.com/office/drawing/2014/main" id="{6B9CBC59-A0E4-84B5-FF04-5A77A3B366A0}"/>
                  </a:ext>
                </a:extLst>
              </p:cNvPr>
              <p:cNvSpPr/>
              <p:nvPr/>
            </p:nvSpPr>
            <p:spPr>
              <a:xfrm>
                <a:off x="10837199" y="681196"/>
                <a:ext cx="200025" cy="152400"/>
              </a:xfrm>
              <a:prstGeom prst="rect">
                <a:avLst/>
              </a:prstGeom>
              <a:solidFill>
                <a:srgbClr val="92D05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A19AB4D-2BEC-88A6-0F19-A9C1B25D71DE}"/>
                  </a:ext>
                </a:extLst>
              </p:cNvPr>
              <p:cNvSpPr txBox="1"/>
              <p:nvPr/>
            </p:nvSpPr>
            <p:spPr>
              <a:xfrm>
                <a:off x="11112787" y="319247"/>
                <a:ext cx="972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H-SY5Y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BA5C061-6C68-9C5B-AEB4-47E8B6769F9B}"/>
                  </a:ext>
                </a:extLst>
              </p:cNvPr>
              <p:cNvSpPr txBox="1"/>
              <p:nvPr/>
            </p:nvSpPr>
            <p:spPr>
              <a:xfrm>
                <a:off x="11112787" y="603508"/>
                <a:ext cx="1512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H-SY5Y Venus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D28259E-28DF-437C-392E-44AE017DFA08}"/>
                </a:ext>
              </a:extLst>
            </p:cNvPr>
            <p:cNvSpPr txBox="1"/>
            <p:nvPr/>
          </p:nvSpPr>
          <p:spPr>
            <a:xfrm>
              <a:off x="9246536" y="406461"/>
              <a:ext cx="5758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Αριστερή αγκύλη 48">
              <a:extLst>
                <a:ext uri="{FF2B5EF4-FFF2-40B4-BE49-F238E27FC236}">
                  <a16:creationId xmlns:a16="http://schemas.microsoft.com/office/drawing/2014/main" id="{C5E63548-5180-9E01-DE6C-801ECF44093A}"/>
                </a:ext>
              </a:extLst>
            </p:cNvPr>
            <p:cNvSpPr/>
            <p:nvPr/>
          </p:nvSpPr>
          <p:spPr>
            <a:xfrm rot="5400000">
              <a:off x="9462436" y="41136"/>
              <a:ext cx="144000" cy="900000"/>
            </a:xfrm>
            <a:prstGeom prst="leftBracket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6933DB8B-0167-0E6D-6DDB-C6F9BD157230}"/>
              </a:ext>
            </a:extLst>
          </p:cNvPr>
          <p:cNvSpPr txBox="1"/>
          <p:nvPr/>
        </p:nvSpPr>
        <p:spPr>
          <a:xfrm>
            <a:off x="95607" y="-98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8E67D9C-AAB0-2825-781F-C5E2C8B862EB}"/>
              </a:ext>
            </a:extLst>
          </p:cNvPr>
          <p:cNvSpPr txBox="1"/>
          <p:nvPr/>
        </p:nvSpPr>
        <p:spPr>
          <a:xfrm>
            <a:off x="113050" y="389599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33 - Ευθεία γραμμή σύνδεσης">
            <a:extLst>
              <a:ext uri="{FF2B5EF4-FFF2-40B4-BE49-F238E27FC236}">
                <a16:creationId xmlns:a16="http://schemas.microsoft.com/office/drawing/2014/main" id="{26BE4620-C9B8-9058-EA8B-69C6CF74FFD4}"/>
              </a:ext>
            </a:extLst>
          </p:cNvPr>
          <p:cNvCxnSpPr/>
          <p:nvPr/>
        </p:nvCxnSpPr>
        <p:spPr>
          <a:xfrm>
            <a:off x="3610997" y="3411959"/>
            <a:ext cx="396000" cy="158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" name="Ομάδα 46">
            <a:extLst>
              <a:ext uri="{FF2B5EF4-FFF2-40B4-BE49-F238E27FC236}">
                <a16:creationId xmlns:a16="http://schemas.microsoft.com/office/drawing/2014/main" id="{EE22030A-AADA-8F4E-13B6-E475C2BA5C8D}"/>
              </a:ext>
            </a:extLst>
          </p:cNvPr>
          <p:cNvGrpSpPr/>
          <p:nvPr/>
        </p:nvGrpSpPr>
        <p:grpSpPr>
          <a:xfrm>
            <a:off x="645952" y="4444199"/>
            <a:ext cx="3643544" cy="1008243"/>
            <a:chOff x="645952" y="4367999"/>
            <a:chExt cx="3643544" cy="100824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C89291C-3541-82F9-4204-B8CBD434EAAD}"/>
                </a:ext>
              </a:extLst>
            </p:cNvPr>
            <p:cNvSpPr txBox="1"/>
            <p:nvPr/>
          </p:nvSpPr>
          <p:spPr>
            <a:xfrm rot="19062323">
              <a:off x="1768302" y="4524954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H-SY5Y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6BA0428-292C-0D38-A961-C724DBE324B1}"/>
                </a:ext>
              </a:extLst>
            </p:cNvPr>
            <p:cNvSpPr txBox="1"/>
            <p:nvPr/>
          </p:nvSpPr>
          <p:spPr>
            <a:xfrm rot="19062323">
              <a:off x="2913215" y="4367999"/>
              <a:ext cx="13083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H-SY5Y Venus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4259BD4-B96E-BA9D-25E5-EB08EBDDA84F}"/>
                </a:ext>
              </a:extLst>
            </p:cNvPr>
            <p:cNvSpPr txBox="1"/>
            <p:nvPr/>
          </p:nvSpPr>
          <p:spPr>
            <a:xfrm>
              <a:off x="645952" y="5099243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7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Ευθύγραμμο βέλος σύνδεσης 21">
              <a:extLst>
                <a:ext uri="{FF2B5EF4-FFF2-40B4-BE49-F238E27FC236}">
                  <a16:creationId xmlns:a16="http://schemas.microsoft.com/office/drawing/2014/main" id="{1D244523-0D3E-2BC9-601C-67E8AE9F7DC3}"/>
                </a:ext>
              </a:extLst>
            </p:cNvPr>
            <p:cNvCxnSpPr>
              <a:cxnSpLocks/>
            </p:cNvCxnSpPr>
            <p:nvPr/>
          </p:nvCxnSpPr>
          <p:spPr>
            <a:xfrm>
              <a:off x="1255424" y="5237742"/>
              <a:ext cx="21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9EC8A00-002E-D4C7-9564-6A75E83CE812}"/>
                </a:ext>
              </a:extLst>
            </p:cNvPr>
            <p:cNvSpPr txBox="1"/>
            <p:nvPr/>
          </p:nvSpPr>
          <p:spPr>
            <a:xfrm>
              <a:off x="3678880" y="5099243"/>
              <a:ext cx="610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Ευθύγραμμο βέλος σύνδεσης 31">
              <a:extLst>
                <a:ext uri="{FF2B5EF4-FFF2-40B4-BE49-F238E27FC236}">
                  <a16:creationId xmlns:a16="http://schemas.microsoft.com/office/drawing/2014/main" id="{F6DFBE96-8E9A-77F3-C374-A6AF27C36B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12522" y="5237742"/>
              <a:ext cx="21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1F7FC5E9-8BCC-9898-A3D3-3F6513203C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" t="9669" r="2723" b="-5444"/>
          <a:stretch/>
        </p:blipFill>
        <p:spPr>
          <a:xfrm>
            <a:off x="1512663" y="5062296"/>
            <a:ext cx="1980670" cy="469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6120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>
            <a:extLst>
              <a:ext uri="{FF2B5EF4-FFF2-40B4-BE49-F238E27FC236}">
                <a16:creationId xmlns:a16="http://schemas.microsoft.com/office/drawing/2014/main" id="{B02D25D2-D4E8-3497-1BC4-C1123D257788}"/>
              </a:ext>
            </a:extLst>
          </p:cNvPr>
          <p:cNvSpPr txBox="1"/>
          <p:nvPr/>
        </p:nvSpPr>
        <p:spPr>
          <a:xfrm>
            <a:off x="-2874" y="-20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Εικόνα 47" descr="Εικόνα που περιέχει κείμενο, γραμματοσειρά, στιγμιότυπο οθόνης, γραμμή&#10;&#10;Περιγραφή που δημιουργήθηκε αυτόματα">
            <a:extLst>
              <a:ext uri="{FF2B5EF4-FFF2-40B4-BE49-F238E27FC236}">
                <a16:creationId xmlns:a16="http://schemas.microsoft.com/office/drawing/2014/main" id="{320D1CAD-FF7A-3662-EC53-823279FCF4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0682" y="554649"/>
            <a:ext cx="7430636" cy="45118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95801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6BBE1EE-4ABE-0F0B-6A18-5A5FC272D943}"/>
              </a:ext>
            </a:extLst>
          </p:cNvPr>
          <p:cNvSpPr txBox="1"/>
          <p:nvPr/>
        </p:nvSpPr>
        <p:spPr>
          <a:xfrm>
            <a:off x="-2874" y="-20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Ομάδα 19">
            <a:extLst>
              <a:ext uri="{FF2B5EF4-FFF2-40B4-BE49-F238E27FC236}">
                <a16:creationId xmlns:a16="http://schemas.microsoft.com/office/drawing/2014/main" id="{023BBBD3-1D1B-9AE4-C490-FC14624E98E2}"/>
              </a:ext>
            </a:extLst>
          </p:cNvPr>
          <p:cNvGrpSpPr/>
          <p:nvPr/>
        </p:nvGrpSpPr>
        <p:grpSpPr>
          <a:xfrm>
            <a:off x="5072929" y="1418330"/>
            <a:ext cx="2046143" cy="3169274"/>
            <a:chOff x="4401312" y="1707579"/>
            <a:chExt cx="2046143" cy="3169274"/>
          </a:xfrm>
        </p:grpSpPr>
        <p:grpSp>
          <p:nvGrpSpPr>
            <p:cNvPr id="18" name="Ομάδα 17">
              <a:extLst>
                <a:ext uri="{FF2B5EF4-FFF2-40B4-BE49-F238E27FC236}">
                  <a16:creationId xmlns:a16="http://schemas.microsoft.com/office/drawing/2014/main" id="{5FCE1F2B-6D26-D56D-7A88-3F393F44A9BD}"/>
                </a:ext>
              </a:extLst>
            </p:cNvPr>
            <p:cNvGrpSpPr/>
            <p:nvPr/>
          </p:nvGrpSpPr>
          <p:grpSpPr>
            <a:xfrm>
              <a:off x="4401312" y="1707579"/>
              <a:ext cx="2046143" cy="2916119"/>
              <a:chOff x="4401312" y="1707579"/>
              <a:chExt cx="2046143" cy="2916119"/>
            </a:xfrm>
          </p:grpSpPr>
          <p:pic>
            <p:nvPicPr>
              <p:cNvPr id="9" name="Εικόνα 8" descr="Εικόνα που περιέχει κείμενο, στιγμιότυπο οθόνης, διάγραμμα, γραμματοσειρά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B6DC5A98-77EB-C3B2-E0CD-3E9775F328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64" r="32321" b="17502"/>
              <a:stretch/>
            </p:blipFill>
            <p:spPr>
              <a:xfrm>
                <a:off x="4973217" y="1828800"/>
                <a:ext cx="1474238" cy="2519265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2FF9732-01EF-E4AE-BF8C-923BAD219309}"/>
                  </a:ext>
                </a:extLst>
              </p:cNvPr>
              <p:cNvSpPr txBox="1"/>
              <p:nvPr/>
            </p:nvSpPr>
            <p:spPr>
              <a:xfrm>
                <a:off x="4632094" y="2479576"/>
                <a:ext cx="399456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4B65341-A973-651D-D2AC-043F283E2378}"/>
                  </a:ext>
                </a:extLst>
              </p:cNvPr>
              <p:cNvSpPr txBox="1"/>
              <p:nvPr/>
            </p:nvSpPr>
            <p:spPr>
              <a:xfrm>
                <a:off x="4632094" y="3023863"/>
                <a:ext cx="399456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4F271D9-EC79-BF06-8A42-2C283E7730E5}"/>
                  </a:ext>
                </a:extLst>
              </p:cNvPr>
              <p:cNvSpPr txBox="1"/>
              <p:nvPr/>
            </p:nvSpPr>
            <p:spPr>
              <a:xfrm>
                <a:off x="4632094" y="3562698"/>
                <a:ext cx="399456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E3BFDAE-EA10-3706-ADAC-E377C83E5260}"/>
                  </a:ext>
                </a:extLst>
              </p:cNvPr>
              <p:cNvSpPr txBox="1"/>
              <p:nvPr/>
            </p:nvSpPr>
            <p:spPr>
              <a:xfrm>
                <a:off x="4632094" y="1947734"/>
                <a:ext cx="399456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3AAA746-34A7-FD84-46C9-A289C553BC32}"/>
                  </a:ext>
                </a:extLst>
              </p:cNvPr>
              <p:cNvSpPr txBox="1"/>
              <p:nvPr/>
            </p:nvSpPr>
            <p:spPr>
              <a:xfrm>
                <a:off x="4722290" y="4099471"/>
                <a:ext cx="219064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3A5F71D-F92F-B2C8-53DC-763AEB8A933C}"/>
                  </a:ext>
                </a:extLst>
              </p:cNvPr>
              <p:cNvSpPr txBox="1"/>
              <p:nvPr/>
            </p:nvSpPr>
            <p:spPr>
              <a:xfrm>
                <a:off x="5243801" y="4310739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0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B3CB9E2-5924-C998-C5B1-3C81D108C58D}"/>
                  </a:ext>
                </a:extLst>
              </p:cNvPr>
              <p:cNvSpPr txBox="1"/>
              <p:nvPr/>
            </p:nvSpPr>
            <p:spPr>
              <a:xfrm>
                <a:off x="5781480" y="4310739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5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F7959A0-1282-1E0D-1D0A-65A81DA10C5A}"/>
                  </a:ext>
                </a:extLst>
              </p:cNvPr>
              <p:cNvSpPr txBox="1"/>
              <p:nvPr/>
            </p:nvSpPr>
            <p:spPr>
              <a:xfrm rot="16200000">
                <a:off x="3097141" y="3011750"/>
                <a:ext cx="29161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t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/total mRNA levels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FDC8CD8-9D34-F932-0564-267BADCF1DCA}"/>
                </a:ext>
              </a:extLst>
            </p:cNvPr>
            <p:cNvSpPr txBox="1"/>
            <p:nvPr/>
          </p:nvSpPr>
          <p:spPr>
            <a:xfrm>
              <a:off x="5277623" y="4569076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36730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784189A-494B-52AB-897E-3A371B5C1998}"/>
              </a:ext>
            </a:extLst>
          </p:cNvPr>
          <p:cNvSpPr txBox="1"/>
          <p:nvPr/>
        </p:nvSpPr>
        <p:spPr>
          <a:xfrm>
            <a:off x="-2874" y="-20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Ομάδα 7">
            <a:extLst>
              <a:ext uri="{FF2B5EF4-FFF2-40B4-BE49-F238E27FC236}">
                <a16:creationId xmlns:a16="http://schemas.microsoft.com/office/drawing/2014/main" id="{196A9D21-D1A8-99F1-23D4-0CA59CC62080}"/>
              </a:ext>
            </a:extLst>
          </p:cNvPr>
          <p:cNvGrpSpPr/>
          <p:nvPr/>
        </p:nvGrpSpPr>
        <p:grpSpPr>
          <a:xfrm>
            <a:off x="2113543" y="1679094"/>
            <a:ext cx="7964914" cy="2679192"/>
            <a:chOff x="1457489" y="1460266"/>
            <a:chExt cx="7964914" cy="2679192"/>
          </a:xfrm>
        </p:grpSpPr>
        <p:pic>
          <p:nvPicPr>
            <p:cNvPr id="4" name="Εικόνα 3">
              <a:extLst>
                <a:ext uri="{FF2B5EF4-FFF2-40B4-BE49-F238E27FC236}">
                  <a16:creationId xmlns:a16="http://schemas.microsoft.com/office/drawing/2014/main" id="{8BEB1447-881E-9600-FD85-5D95B2E146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457489" y="1460266"/>
              <a:ext cx="3712464" cy="2679192"/>
            </a:xfrm>
            <a:prstGeom prst="rect">
              <a:avLst/>
            </a:prstGeom>
          </p:spPr>
        </p:pic>
        <p:pic>
          <p:nvPicPr>
            <p:cNvPr id="7" name="Εικόνα 6">
              <a:extLst>
                <a:ext uri="{FF2B5EF4-FFF2-40B4-BE49-F238E27FC236}">
                  <a16:creationId xmlns:a16="http://schemas.microsoft.com/office/drawing/2014/main" id="{76C1BAF2-B3F1-51F5-503D-02094BA6EA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473719" y="1460266"/>
              <a:ext cx="3948684" cy="26791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133240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3CC22D7-51E2-9B3B-11F1-A394B2F94CB0}"/>
              </a:ext>
            </a:extLst>
          </p:cNvPr>
          <p:cNvSpPr txBox="1"/>
          <p:nvPr/>
        </p:nvSpPr>
        <p:spPr>
          <a:xfrm>
            <a:off x="-2874" y="-20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Ομάδα 58">
            <a:extLst>
              <a:ext uri="{FF2B5EF4-FFF2-40B4-BE49-F238E27FC236}">
                <a16:creationId xmlns:a16="http://schemas.microsoft.com/office/drawing/2014/main" id="{DCA62B12-1AEE-664D-9471-CCDD2A0B8953}"/>
              </a:ext>
            </a:extLst>
          </p:cNvPr>
          <p:cNvGrpSpPr/>
          <p:nvPr/>
        </p:nvGrpSpPr>
        <p:grpSpPr>
          <a:xfrm>
            <a:off x="4587938" y="813473"/>
            <a:ext cx="2358099" cy="2475210"/>
            <a:chOff x="6766703" y="829077"/>
            <a:chExt cx="2358099" cy="2475210"/>
          </a:xfrm>
        </p:grpSpPr>
        <p:pic>
          <p:nvPicPr>
            <p:cNvPr id="8" name="Εικόνα 7" descr="Εικόνα που περιέχει κείμενο, στιγμιότυπο οθόνης, διάγραμμα, γραμματοσειρά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96475507-9AC6-9998-1986-9E1793DB99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27" r="34388" b="11007"/>
            <a:stretch/>
          </p:blipFill>
          <p:spPr>
            <a:xfrm>
              <a:off x="7794594" y="836760"/>
              <a:ext cx="1330208" cy="2160504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C21EC0A-8CB2-8414-C13A-D89C1F4C4A7D}"/>
                </a:ext>
              </a:extLst>
            </p:cNvPr>
            <p:cNvSpPr txBox="1"/>
            <p:nvPr/>
          </p:nvSpPr>
          <p:spPr>
            <a:xfrm>
              <a:off x="8562982" y="302728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C78F067-3A77-199D-3E98-036371967F8D}"/>
                </a:ext>
              </a:extLst>
            </p:cNvPr>
            <p:cNvSpPr txBox="1"/>
            <p:nvPr/>
          </p:nvSpPr>
          <p:spPr>
            <a:xfrm>
              <a:off x="7924801" y="3027288"/>
              <a:ext cx="610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C52577E-B7FC-2E27-56A4-DCC6EFB7873B}"/>
                </a:ext>
              </a:extLst>
            </p:cNvPr>
            <p:cNvSpPr txBox="1"/>
            <p:nvPr/>
          </p:nvSpPr>
          <p:spPr>
            <a:xfrm>
              <a:off x="7214557" y="2316419"/>
              <a:ext cx="64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lang="el-GR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FF272BB-3757-A3C2-E712-2F072867EE15}"/>
                </a:ext>
              </a:extLst>
            </p:cNvPr>
            <p:cNvSpPr txBox="1"/>
            <p:nvPr/>
          </p:nvSpPr>
          <p:spPr>
            <a:xfrm>
              <a:off x="7214557" y="1833959"/>
              <a:ext cx="64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lang="el-GR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B0BEBB6-DB80-5825-B964-67ED41391370}"/>
                </a:ext>
              </a:extLst>
            </p:cNvPr>
            <p:cNvSpPr txBox="1"/>
            <p:nvPr/>
          </p:nvSpPr>
          <p:spPr>
            <a:xfrm>
              <a:off x="7214557" y="1382358"/>
              <a:ext cx="64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lang="el-GR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C96B327-D947-4475-83C1-346455342329}"/>
                </a:ext>
              </a:extLst>
            </p:cNvPr>
            <p:cNvSpPr txBox="1"/>
            <p:nvPr/>
          </p:nvSpPr>
          <p:spPr>
            <a:xfrm>
              <a:off x="7214557" y="934719"/>
              <a:ext cx="64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x10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  <a:endParaRPr lang="el-GR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5E66491-B726-1D51-4198-4949A7B57264}"/>
                </a:ext>
              </a:extLst>
            </p:cNvPr>
            <p:cNvSpPr txBox="1"/>
            <p:nvPr/>
          </p:nvSpPr>
          <p:spPr>
            <a:xfrm>
              <a:off x="7412557" y="2797001"/>
              <a:ext cx="252000" cy="283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4A4C9DD-E450-796A-8725-AF56DC3F0EB1}"/>
                </a:ext>
              </a:extLst>
            </p:cNvPr>
            <p:cNvSpPr txBox="1"/>
            <p:nvPr/>
          </p:nvSpPr>
          <p:spPr>
            <a:xfrm rot="16200000">
              <a:off x="6048085" y="1777189"/>
              <a:ext cx="192967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5.8S+ITS2 pre-rRNA abundance</a:t>
              </a:r>
              <a:endParaRPr lang="el-GR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03D3154-1E9D-608A-28F4-88C5568590C8}"/>
                </a:ext>
              </a:extLst>
            </p:cNvPr>
            <p:cNvSpPr txBox="1"/>
            <p:nvPr/>
          </p:nvSpPr>
          <p:spPr>
            <a:xfrm>
              <a:off x="8356109" y="829077"/>
              <a:ext cx="216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  <a:p>
              <a:pPr algn="ctr"/>
              <a:endParaRPr 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Ευθεία γραμμή σύνδεσης 50">
              <a:extLst>
                <a:ext uri="{FF2B5EF4-FFF2-40B4-BE49-F238E27FC236}">
                  <a16:creationId xmlns:a16="http://schemas.microsoft.com/office/drawing/2014/main" id="{67EAA41E-AAAD-D5D1-9DF9-B8306C38FC75}"/>
                </a:ext>
              </a:extLst>
            </p:cNvPr>
            <p:cNvCxnSpPr>
              <a:cxnSpLocks/>
            </p:cNvCxnSpPr>
            <p:nvPr/>
          </p:nvCxnSpPr>
          <p:spPr>
            <a:xfrm>
              <a:off x="8230109" y="1078675"/>
              <a:ext cx="46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Ομάδα 60">
            <a:extLst>
              <a:ext uri="{FF2B5EF4-FFF2-40B4-BE49-F238E27FC236}">
                <a16:creationId xmlns:a16="http://schemas.microsoft.com/office/drawing/2014/main" id="{350BD4C9-59D9-5F8E-6012-3B13C52F76B3}"/>
              </a:ext>
            </a:extLst>
          </p:cNvPr>
          <p:cNvGrpSpPr/>
          <p:nvPr/>
        </p:nvGrpSpPr>
        <p:grpSpPr>
          <a:xfrm>
            <a:off x="1579440" y="773374"/>
            <a:ext cx="2177885" cy="2555408"/>
            <a:chOff x="938177" y="732718"/>
            <a:chExt cx="2177885" cy="2555408"/>
          </a:xfrm>
        </p:grpSpPr>
        <p:grpSp>
          <p:nvGrpSpPr>
            <p:cNvPr id="23" name="Ομάδα 22">
              <a:extLst>
                <a:ext uri="{FF2B5EF4-FFF2-40B4-BE49-F238E27FC236}">
                  <a16:creationId xmlns:a16="http://schemas.microsoft.com/office/drawing/2014/main" id="{B1191BF6-3075-7557-78F6-7B55CA43D6C6}"/>
                </a:ext>
              </a:extLst>
            </p:cNvPr>
            <p:cNvGrpSpPr/>
            <p:nvPr/>
          </p:nvGrpSpPr>
          <p:grpSpPr>
            <a:xfrm>
              <a:off x="938177" y="732718"/>
              <a:ext cx="2177885" cy="2555408"/>
              <a:chOff x="938177" y="732718"/>
              <a:chExt cx="2177885" cy="2555408"/>
            </a:xfrm>
          </p:grpSpPr>
          <p:pic>
            <p:nvPicPr>
              <p:cNvPr id="14" name="Εικόνα 13" descr="Εικόνα που περιέχει κείμενο, στιγμιότυπο οθόνης, διάγραμμα, γραμματοσειρά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0F715CDB-5F40-150C-90ED-D3916F5854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865" r="35961" b="9959"/>
              <a:stretch/>
            </p:blipFill>
            <p:spPr>
              <a:xfrm>
                <a:off x="1846555" y="732718"/>
                <a:ext cx="1269507" cy="2303445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67E5895-012F-5663-2ACE-008AC256FDA0}"/>
                  </a:ext>
                </a:extLst>
              </p:cNvPr>
              <p:cNvSpPr txBox="1"/>
              <p:nvPr/>
            </p:nvSpPr>
            <p:spPr>
              <a:xfrm>
                <a:off x="1444370" y="2832513"/>
                <a:ext cx="252000" cy="283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BF2FA67-EF22-4402-9073-4BCCB95DB744}"/>
                  </a:ext>
                </a:extLst>
              </p:cNvPr>
              <p:cNvSpPr txBox="1"/>
              <p:nvPr/>
            </p:nvSpPr>
            <p:spPr>
              <a:xfrm>
                <a:off x="1246370" y="2146104"/>
                <a:ext cx="648000" cy="252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02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B5B74C2-E9E4-7BA8-F3EB-B71F6AA72C17}"/>
                  </a:ext>
                </a:extLst>
              </p:cNvPr>
              <p:cNvSpPr txBox="1"/>
              <p:nvPr/>
            </p:nvSpPr>
            <p:spPr>
              <a:xfrm>
                <a:off x="1246370" y="1488127"/>
                <a:ext cx="648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04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0FFCB8B-9097-6B20-A906-9B4520A844D8}"/>
                  </a:ext>
                </a:extLst>
              </p:cNvPr>
              <p:cNvSpPr txBox="1"/>
              <p:nvPr/>
            </p:nvSpPr>
            <p:spPr>
              <a:xfrm>
                <a:off x="1246370" y="836760"/>
                <a:ext cx="648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06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0596659-72BD-FF61-6AF8-24573FAC8795}"/>
                  </a:ext>
                </a:extLst>
              </p:cNvPr>
              <p:cNvSpPr txBox="1"/>
              <p:nvPr/>
            </p:nvSpPr>
            <p:spPr>
              <a:xfrm>
                <a:off x="2551318" y="3011127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5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1C38057-00C4-E806-0E0B-769CA5F16134}"/>
                  </a:ext>
                </a:extLst>
              </p:cNvPr>
              <p:cNvSpPr txBox="1"/>
              <p:nvPr/>
            </p:nvSpPr>
            <p:spPr>
              <a:xfrm>
                <a:off x="1913139" y="3011127"/>
                <a:ext cx="610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Venus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6FE1ED0-55FA-8BEE-5BB3-A9EF2E72074B}"/>
                  </a:ext>
                </a:extLst>
              </p:cNvPr>
              <p:cNvSpPr txBox="1"/>
              <p:nvPr/>
            </p:nvSpPr>
            <p:spPr>
              <a:xfrm rot="16200000">
                <a:off x="465138" y="1641013"/>
                <a:ext cx="1238466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ITS-1 levels</a:t>
                </a:r>
                <a:endParaRPr lang="el-GR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48678AA-6144-E128-5D46-AD8D6712343C}"/>
                </a:ext>
              </a:extLst>
            </p:cNvPr>
            <p:cNvSpPr txBox="1"/>
            <p:nvPr/>
          </p:nvSpPr>
          <p:spPr>
            <a:xfrm>
              <a:off x="2367126" y="769850"/>
              <a:ext cx="216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  <a:p>
              <a:pPr algn="ctr"/>
              <a:endParaRPr 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Ευθεία γραμμή σύνδεσης 52">
              <a:extLst>
                <a:ext uri="{FF2B5EF4-FFF2-40B4-BE49-F238E27FC236}">
                  <a16:creationId xmlns:a16="http://schemas.microsoft.com/office/drawing/2014/main" id="{210DFC79-233A-3444-3993-0BFA42659047}"/>
                </a:ext>
              </a:extLst>
            </p:cNvPr>
            <p:cNvCxnSpPr>
              <a:cxnSpLocks/>
            </p:cNvCxnSpPr>
            <p:nvPr/>
          </p:nvCxnSpPr>
          <p:spPr>
            <a:xfrm>
              <a:off x="2214492" y="1019448"/>
              <a:ext cx="46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0" name="Ομάδα 59">
            <a:extLst>
              <a:ext uri="{FF2B5EF4-FFF2-40B4-BE49-F238E27FC236}">
                <a16:creationId xmlns:a16="http://schemas.microsoft.com/office/drawing/2014/main" id="{6543A54F-92F2-22B6-2C25-6E0A045595E5}"/>
              </a:ext>
            </a:extLst>
          </p:cNvPr>
          <p:cNvGrpSpPr/>
          <p:nvPr/>
        </p:nvGrpSpPr>
        <p:grpSpPr>
          <a:xfrm>
            <a:off x="8117326" y="841150"/>
            <a:ext cx="2282696" cy="2419856"/>
            <a:chOff x="3931673" y="875659"/>
            <a:chExt cx="2282696" cy="2419856"/>
          </a:xfrm>
        </p:grpSpPr>
        <p:pic>
          <p:nvPicPr>
            <p:cNvPr id="25" name="Εικόνα 24" descr="Εικόνα που περιέχει κείμενο, στιγμιότυπο οθόνης, σχεδίαση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8B364751-29ED-1E94-35F4-43E2367083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70" r="17022" b="10980"/>
            <a:stretch/>
          </p:blipFill>
          <p:spPr>
            <a:xfrm>
              <a:off x="4856085" y="875659"/>
              <a:ext cx="1358284" cy="2160504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FA2F8C-D8E6-3FBD-0892-669DEB8C814C}"/>
                </a:ext>
              </a:extLst>
            </p:cNvPr>
            <p:cNvSpPr txBox="1"/>
            <p:nvPr/>
          </p:nvSpPr>
          <p:spPr>
            <a:xfrm>
              <a:off x="4521795" y="2797001"/>
              <a:ext cx="252000" cy="283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5068823-55EC-39B0-599C-618105776616}"/>
                </a:ext>
              </a:extLst>
            </p:cNvPr>
            <p:cNvSpPr txBox="1"/>
            <p:nvPr/>
          </p:nvSpPr>
          <p:spPr>
            <a:xfrm>
              <a:off x="4413795" y="2353482"/>
              <a:ext cx="468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ADCA28E-FCE8-531B-4F55-FB75FEE76CB7}"/>
                </a:ext>
              </a:extLst>
            </p:cNvPr>
            <p:cNvSpPr txBox="1"/>
            <p:nvPr/>
          </p:nvSpPr>
          <p:spPr>
            <a:xfrm>
              <a:off x="4377795" y="1897245"/>
              <a:ext cx="540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F689A16-2EC7-861D-B5BA-9A911250D3A3}"/>
                </a:ext>
              </a:extLst>
            </p:cNvPr>
            <p:cNvSpPr txBox="1"/>
            <p:nvPr/>
          </p:nvSpPr>
          <p:spPr>
            <a:xfrm>
              <a:off x="4377795" y="1443537"/>
              <a:ext cx="540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0352FA2-AF49-C417-2706-987850347AB1}"/>
                </a:ext>
              </a:extLst>
            </p:cNvPr>
            <p:cNvSpPr txBox="1"/>
            <p:nvPr/>
          </p:nvSpPr>
          <p:spPr>
            <a:xfrm>
              <a:off x="4377795" y="991140"/>
              <a:ext cx="540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CB9AFD7-0DB8-7463-A4C8-67C6F8C68FAD}"/>
                </a:ext>
              </a:extLst>
            </p:cNvPr>
            <p:cNvSpPr txBox="1"/>
            <p:nvPr/>
          </p:nvSpPr>
          <p:spPr>
            <a:xfrm>
              <a:off x="5609242" y="301851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81D57BA-C20F-9FD3-226D-A35AB29B71E2}"/>
                </a:ext>
              </a:extLst>
            </p:cNvPr>
            <p:cNvSpPr txBox="1"/>
            <p:nvPr/>
          </p:nvSpPr>
          <p:spPr>
            <a:xfrm>
              <a:off x="4962185" y="3018516"/>
              <a:ext cx="610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nus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A7CB7FF-3B48-AE61-2B3E-6D44EC2B0ED7}"/>
                </a:ext>
              </a:extLst>
            </p:cNvPr>
            <p:cNvSpPr txBox="1"/>
            <p:nvPr/>
          </p:nvSpPr>
          <p:spPr>
            <a:xfrm rot="16200000">
              <a:off x="3295895" y="1752836"/>
              <a:ext cx="1764000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28S+ETS pre-rRNA abundance</a:t>
              </a:r>
              <a:endParaRPr lang="el-GR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7B29EC9-5D80-70B4-5C51-C64706A04DE0}"/>
                </a:ext>
              </a:extLst>
            </p:cNvPr>
            <p:cNvSpPr txBox="1"/>
            <p:nvPr/>
          </p:nvSpPr>
          <p:spPr>
            <a:xfrm>
              <a:off x="5389632" y="1176345"/>
              <a:ext cx="216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  <a:p>
              <a:pPr algn="ctr"/>
              <a:endParaRPr 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Ευθεία γραμμή σύνδεσης 54">
              <a:extLst>
                <a:ext uri="{FF2B5EF4-FFF2-40B4-BE49-F238E27FC236}">
                  <a16:creationId xmlns:a16="http://schemas.microsoft.com/office/drawing/2014/main" id="{9CCB0C24-7F9E-36CE-B29A-6BF5081D73FE}"/>
                </a:ext>
              </a:extLst>
            </p:cNvPr>
            <p:cNvCxnSpPr>
              <a:cxnSpLocks/>
            </p:cNvCxnSpPr>
            <p:nvPr/>
          </p:nvCxnSpPr>
          <p:spPr>
            <a:xfrm>
              <a:off x="5263632" y="1425943"/>
              <a:ext cx="468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8456AD00-633C-86FB-7C13-CC0AFA0B01D1}"/>
              </a:ext>
            </a:extLst>
          </p:cNvPr>
          <p:cNvSpPr txBox="1"/>
          <p:nvPr/>
        </p:nvSpPr>
        <p:spPr>
          <a:xfrm>
            <a:off x="1127729" y="6112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C7F6EE3-982B-43A8-18D8-300A1BD29282}"/>
              </a:ext>
            </a:extLst>
          </p:cNvPr>
          <p:cNvSpPr txBox="1"/>
          <p:nvPr/>
        </p:nvSpPr>
        <p:spPr>
          <a:xfrm>
            <a:off x="7564633" y="6112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CB9A1B2-7688-94ED-A0A6-7D3F6759945D}"/>
              </a:ext>
            </a:extLst>
          </p:cNvPr>
          <p:cNvSpPr txBox="1"/>
          <p:nvPr/>
        </p:nvSpPr>
        <p:spPr>
          <a:xfrm>
            <a:off x="4143966" y="6112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29866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511A3DD-6C6B-0341-9464-151A1712572A}"/>
              </a:ext>
            </a:extLst>
          </p:cNvPr>
          <p:cNvSpPr txBox="1"/>
          <p:nvPr/>
        </p:nvSpPr>
        <p:spPr>
          <a:xfrm>
            <a:off x="95607" y="-98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Ομάδα 18">
            <a:extLst>
              <a:ext uri="{FF2B5EF4-FFF2-40B4-BE49-F238E27FC236}">
                <a16:creationId xmlns:a16="http://schemas.microsoft.com/office/drawing/2014/main" id="{F869B4A8-23D1-FEBF-D68A-DA06729427E6}"/>
              </a:ext>
            </a:extLst>
          </p:cNvPr>
          <p:cNvGrpSpPr/>
          <p:nvPr/>
        </p:nvGrpSpPr>
        <p:grpSpPr>
          <a:xfrm>
            <a:off x="4027728" y="1363224"/>
            <a:ext cx="3670996" cy="2713625"/>
            <a:chOff x="6948481" y="3955501"/>
            <a:chExt cx="3670996" cy="2713625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3EDF1C4-F02A-7AA2-7DC6-04AAA4F5CF39}"/>
                </a:ext>
              </a:extLst>
            </p:cNvPr>
            <p:cNvSpPr txBox="1"/>
            <p:nvPr/>
          </p:nvSpPr>
          <p:spPr>
            <a:xfrm>
              <a:off x="7314211" y="6143805"/>
              <a:ext cx="217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A57049B-1C06-1819-261A-567AD636BF44}"/>
                </a:ext>
              </a:extLst>
            </p:cNvPr>
            <p:cNvSpPr txBox="1"/>
            <p:nvPr/>
          </p:nvSpPr>
          <p:spPr>
            <a:xfrm>
              <a:off x="7209436" y="5639724"/>
              <a:ext cx="4267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59E679E-9023-4CCE-6991-0E9054792977}"/>
                </a:ext>
              </a:extLst>
            </p:cNvPr>
            <p:cNvSpPr txBox="1"/>
            <p:nvPr/>
          </p:nvSpPr>
          <p:spPr>
            <a:xfrm>
              <a:off x="7314211" y="5104600"/>
              <a:ext cx="217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DC9CD03-A724-6CB5-A1DD-72450E014E88}"/>
                </a:ext>
              </a:extLst>
            </p:cNvPr>
            <p:cNvSpPr txBox="1"/>
            <p:nvPr/>
          </p:nvSpPr>
          <p:spPr>
            <a:xfrm>
              <a:off x="7209436" y="4588504"/>
              <a:ext cx="4267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DAB7DD8-FC67-9278-B736-98189689611F}"/>
                </a:ext>
              </a:extLst>
            </p:cNvPr>
            <p:cNvSpPr txBox="1"/>
            <p:nvPr/>
          </p:nvSpPr>
          <p:spPr>
            <a:xfrm>
              <a:off x="7314211" y="4066502"/>
              <a:ext cx="217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6BBFF85-1BC4-BDCC-E4E1-E286D941417B}"/>
                </a:ext>
              </a:extLst>
            </p:cNvPr>
            <p:cNvSpPr txBox="1"/>
            <p:nvPr/>
          </p:nvSpPr>
          <p:spPr>
            <a:xfrm>
              <a:off x="7943252" y="6392127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7A80012-E801-DDDB-D3E7-F9F38456868E}"/>
                </a:ext>
              </a:extLst>
            </p:cNvPr>
            <p:cNvSpPr txBox="1"/>
            <p:nvPr/>
          </p:nvSpPr>
          <p:spPr>
            <a:xfrm>
              <a:off x="9128524" y="6392127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K529N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19A7122-F93A-A3AA-700D-40E1B25355F8}"/>
                </a:ext>
              </a:extLst>
            </p:cNvPr>
            <p:cNvSpPr txBox="1"/>
            <p:nvPr/>
          </p:nvSpPr>
          <p:spPr>
            <a:xfrm rot="16200000">
              <a:off x="6467420" y="5031584"/>
              <a:ext cx="12698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irefly/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Renilla</a:t>
              </a:r>
              <a:endParaRPr lang="el-G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Εικόνα 27">
              <a:extLst>
                <a:ext uri="{FF2B5EF4-FFF2-40B4-BE49-F238E27FC236}">
                  <a16:creationId xmlns:a16="http://schemas.microsoft.com/office/drawing/2014/main" id="{A2A9C79B-1C39-0841-7C00-0437B475FA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67" r="18985" b="9634"/>
            <a:stretch/>
          </p:blipFill>
          <p:spPr>
            <a:xfrm>
              <a:off x="7527607" y="3955501"/>
              <a:ext cx="2537926" cy="2458079"/>
            </a:xfrm>
            <a:prstGeom prst="rect">
              <a:avLst/>
            </a:prstGeom>
          </p:spPr>
        </p:pic>
        <p:grpSp>
          <p:nvGrpSpPr>
            <p:cNvPr id="29" name="Ομάδα 28">
              <a:extLst>
                <a:ext uri="{FF2B5EF4-FFF2-40B4-BE49-F238E27FC236}">
                  <a16:creationId xmlns:a16="http://schemas.microsoft.com/office/drawing/2014/main" id="{4CCBC8DC-B581-F476-9D88-FC0E3667E5D1}"/>
                </a:ext>
              </a:extLst>
            </p:cNvPr>
            <p:cNvGrpSpPr/>
            <p:nvPr/>
          </p:nvGrpSpPr>
          <p:grpSpPr>
            <a:xfrm>
              <a:off x="9313647" y="5395695"/>
              <a:ext cx="486783" cy="244227"/>
              <a:chOff x="8345462" y="1591694"/>
              <a:chExt cx="486783" cy="244227"/>
            </a:xfrm>
          </p:grpSpPr>
          <p:cxnSp>
            <p:nvCxnSpPr>
              <p:cNvPr id="33" name="Ευθεία γραμμή σύνδεσης 32">
                <a:extLst>
                  <a:ext uri="{FF2B5EF4-FFF2-40B4-BE49-F238E27FC236}">
                    <a16:creationId xmlns:a16="http://schemas.microsoft.com/office/drawing/2014/main" id="{761305EC-DE44-EE7B-2D52-6E83AFD6C4FD}"/>
                  </a:ext>
                </a:extLst>
              </p:cNvPr>
              <p:cNvCxnSpPr/>
              <p:nvPr/>
            </p:nvCxnSpPr>
            <p:spPr>
              <a:xfrm>
                <a:off x="8345462" y="1835921"/>
                <a:ext cx="468000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E9D6D54-0D69-7533-203C-BC6EEC60D36B}"/>
                  </a:ext>
                </a:extLst>
              </p:cNvPr>
              <p:cNvSpPr txBox="1"/>
              <p:nvPr/>
            </p:nvSpPr>
            <p:spPr>
              <a:xfrm>
                <a:off x="8364245" y="1591694"/>
                <a:ext cx="46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5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pic>
          <p:nvPicPr>
            <p:cNvPr id="30" name="Εικόνα 29" descr="Εικόνα που περιέχει διάγραμμα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B134F918-14F2-D8E1-513E-C03F7545F0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40" t="11993" r="45727" b="61022"/>
            <a:stretch/>
          </p:blipFill>
          <p:spPr>
            <a:xfrm>
              <a:off x="10018936" y="4103378"/>
              <a:ext cx="330036" cy="68898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F51CBFC-C9E9-DA5F-76E2-6904EDD79DBF}"/>
                </a:ext>
              </a:extLst>
            </p:cNvPr>
            <p:cNvSpPr txBox="1"/>
            <p:nvPr/>
          </p:nvSpPr>
          <p:spPr>
            <a:xfrm>
              <a:off x="10239245" y="417047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91D9E4B-7A18-48C4-703F-E7ABEF85F2FB}"/>
                </a:ext>
              </a:extLst>
            </p:cNvPr>
            <p:cNvSpPr txBox="1"/>
            <p:nvPr/>
          </p:nvSpPr>
          <p:spPr>
            <a:xfrm>
              <a:off x="10239245" y="440310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570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63A4576-5FB5-7CF4-CB21-D3DE08631CD9}"/>
              </a:ext>
            </a:extLst>
          </p:cNvPr>
          <p:cNvSpPr txBox="1"/>
          <p:nvPr/>
        </p:nvSpPr>
        <p:spPr>
          <a:xfrm>
            <a:off x="95607" y="-98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Ομάδα 50">
            <a:extLst>
              <a:ext uri="{FF2B5EF4-FFF2-40B4-BE49-F238E27FC236}">
                <a16:creationId xmlns:a16="http://schemas.microsoft.com/office/drawing/2014/main" id="{30FD4839-EC80-B210-5404-88D8B138C4EF}"/>
              </a:ext>
            </a:extLst>
          </p:cNvPr>
          <p:cNvGrpSpPr/>
          <p:nvPr/>
        </p:nvGrpSpPr>
        <p:grpSpPr>
          <a:xfrm>
            <a:off x="6096000" y="1187178"/>
            <a:ext cx="5314989" cy="2980107"/>
            <a:chOff x="6096000" y="939433"/>
            <a:chExt cx="5314989" cy="2980107"/>
          </a:xfrm>
        </p:grpSpPr>
        <p:grpSp>
          <p:nvGrpSpPr>
            <p:cNvPr id="28" name="Ομάδα 27">
              <a:extLst>
                <a:ext uri="{FF2B5EF4-FFF2-40B4-BE49-F238E27FC236}">
                  <a16:creationId xmlns:a16="http://schemas.microsoft.com/office/drawing/2014/main" id="{FC939942-AAF3-A59B-9A2B-D79EB3D23C7B}"/>
                </a:ext>
              </a:extLst>
            </p:cNvPr>
            <p:cNvGrpSpPr/>
            <p:nvPr/>
          </p:nvGrpSpPr>
          <p:grpSpPr>
            <a:xfrm>
              <a:off x="6096000" y="1359675"/>
              <a:ext cx="5314989" cy="2559865"/>
              <a:chOff x="204643" y="969150"/>
              <a:chExt cx="5314989" cy="2559865"/>
            </a:xfrm>
          </p:grpSpPr>
          <p:pic>
            <p:nvPicPr>
              <p:cNvPr id="9" name="Εικόνα 8" descr="Εικόνα που περιέχει μαύρο, ασπρόμαυρο, μονοχρωματική φωτογραφία, μονοχρωματικό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8827C0C9-424A-A25F-6629-26678C4AEA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62" b="-2997"/>
              <a:stretch/>
            </p:blipFill>
            <p:spPr>
              <a:xfrm>
                <a:off x="1121865" y="2627476"/>
                <a:ext cx="3276000" cy="901539"/>
              </a:xfrm>
              <a:prstGeom prst="rect">
                <a:avLst/>
              </a:prstGeom>
            </p:spPr>
          </p:pic>
          <p:pic>
            <p:nvPicPr>
              <p:cNvPr id="11" name="Εικόνα 10" descr="Εικόνα που περιέχει κείμενο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7D891576-D1D2-431E-FB56-9CD645752C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21865" y="1798313"/>
                <a:ext cx="3276000" cy="655200"/>
              </a:xfrm>
              <a:prstGeom prst="rect">
                <a:avLst/>
              </a:prstGeom>
            </p:spPr>
          </p:pic>
          <p:pic>
            <p:nvPicPr>
              <p:cNvPr id="13" name="Εικόνα 12" descr="Εικόνα που περιέχει λευκό, στιγμιότυπο οθόνης, σχεδίαση&#10;&#10;Περιγραφή που δημιουργήθηκε αυτόματα">
                <a:extLst>
                  <a:ext uri="{FF2B5EF4-FFF2-40B4-BE49-F238E27FC236}">
                    <a16:creationId xmlns:a16="http://schemas.microsoft.com/office/drawing/2014/main" id="{650640E5-3E73-36B1-FEFB-C025113EAF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21865" y="969150"/>
                <a:ext cx="3276000" cy="655200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8842B92-F36B-87B6-52A7-5216B7457C31}"/>
                  </a:ext>
                </a:extLst>
              </p:cNvPr>
              <p:cNvSpPr txBox="1"/>
              <p:nvPr/>
            </p:nvSpPr>
            <p:spPr>
              <a:xfrm>
                <a:off x="4589823" y="1190404"/>
                <a:ext cx="7473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taxin-1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D93627C-893C-D15E-177B-66B305B1167C}"/>
                  </a:ext>
                </a:extLst>
              </p:cNvPr>
              <p:cNvSpPr txBox="1"/>
              <p:nvPr/>
            </p:nvSpPr>
            <p:spPr>
              <a:xfrm>
                <a:off x="204643" y="1190404"/>
                <a:ext cx="7553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Ευθύγραμμο βέλος σύνδεσης 16">
                <a:extLst>
                  <a:ext uri="{FF2B5EF4-FFF2-40B4-BE49-F238E27FC236}">
                    <a16:creationId xmlns:a16="http://schemas.microsoft.com/office/drawing/2014/main" id="{6CDB9ED3-E6B0-91F8-93EC-678CF79D5E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635" y="1342220"/>
                <a:ext cx="216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Ευθύγραμμο βέλος σύνδεσης 17">
                <a:extLst>
                  <a:ext uri="{FF2B5EF4-FFF2-40B4-BE49-F238E27FC236}">
                    <a16:creationId xmlns:a16="http://schemas.microsoft.com/office/drawing/2014/main" id="{001989EE-77B2-C914-B954-034B385914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10887" y="1342220"/>
                <a:ext cx="216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CA7CF06-791C-4701-663B-88ECF5AC9C13}"/>
                  </a:ext>
                </a:extLst>
              </p:cNvPr>
              <p:cNvSpPr txBox="1"/>
              <p:nvPr/>
            </p:nvSpPr>
            <p:spPr>
              <a:xfrm>
                <a:off x="4626887" y="1826948"/>
                <a:ext cx="8927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amin A/C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Αριστερή αγκύλη 19">
                <a:extLst>
                  <a:ext uri="{FF2B5EF4-FFF2-40B4-BE49-F238E27FC236}">
                    <a16:creationId xmlns:a16="http://schemas.microsoft.com/office/drawing/2014/main" id="{35D3AA37-E778-ED16-A446-F5B2B615FF1B}"/>
                  </a:ext>
                </a:extLst>
              </p:cNvPr>
              <p:cNvSpPr/>
              <p:nvPr/>
            </p:nvSpPr>
            <p:spPr>
              <a:xfrm rot="10800000">
                <a:off x="4442893" y="1908297"/>
                <a:ext cx="98794" cy="180000"/>
              </a:xfrm>
              <a:prstGeom prst="lef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56CB982-F228-EE07-E288-516A167DF3A7}"/>
                  </a:ext>
                </a:extLst>
              </p:cNvPr>
              <p:cNvSpPr txBox="1"/>
              <p:nvPr/>
            </p:nvSpPr>
            <p:spPr>
              <a:xfrm>
                <a:off x="289602" y="1826948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D33E3F6-48F3-82AF-2889-3D74F418E743}"/>
                  </a:ext>
                </a:extLst>
              </p:cNvPr>
              <p:cNvSpPr txBox="1"/>
              <p:nvPr/>
            </p:nvSpPr>
            <p:spPr>
              <a:xfrm>
                <a:off x="4626887" y="2810024"/>
                <a:ext cx="7312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Ευθύγραμμο βέλος σύνδεσης 23">
                <a:extLst>
                  <a:ext uri="{FF2B5EF4-FFF2-40B4-BE49-F238E27FC236}">
                    <a16:creationId xmlns:a16="http://schemas.microsoft.com/office/drawing/2014/main" id="{D87712E2-8C57-036F-8FAD-765601068C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3160" y="2962113"/>
                <a:ext cx="216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A9AE0B3-F479-764D-B2C6-A6E6706791BF}"/>
                  </a:ext>
                </a:extLst>
              </p:cNvPr>
              <p:cNvSpPr txBox="1"/>
              <p:nvPr/>
            </p:nvSpPr>
            <p:spPr>
              <a:xfrm>
                <a:off x="289602" y="2810024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l-GR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" name="Ευθύγραμμο βέλος σύνδεσης 25">
                <a:extLst>
                  <a:ext uri="{FF2B5EF4-FFF2-40B4-BE49-F238E27FC236}">
                    <a16:creationId xmlns:a16="http://schemas.microsoft.com/office/drawing/2014/main" id="{688C6036-2A7B-CE58-965E-4F903323A42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47951" y="2952688"/>
                <a:ext cx="216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Ευθύγραμμο βέλος σύνδεσης 26">
                <a:extLst>
                  <a:ext uri="{FF2B5EF4-FFF2-40B4-BE49-F238E27FC236}">
                    <a16:creationId xmlns:a16="http://schemas.microsoft.com/office/drawing/2014/main" id="{2FBD1813-3F37-CD31-0989-580040AA31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3635" y="1987967"/>
                <a:ext cx="216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8157AE2-507B-449B-71E7-3BFDB0E7C233}"/>
                </a:ext>
              </a:extLst>
            </p:cNvPr>
            <p:cNvSpPr txBox="1"/>
            <p:nvPr/>
          </p:nvSpPr>
          <p:spPr>
            <a:xfrm rot="19748623">
              <a:off x="8055899" y="1042055"/>
              <a:ext cx="5090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D1995CC-3012-C92B-F272-D8A9FB954002}"/>
                </a:ext>
              </a:extLst>
            </p:cNvPr>
            <p:cNvSpPr txBox="1"/>
            <p:nvPr/>
          </p:nvSpPr>
          <p:spPr>
            <a:xfrm rot="19748623">
              <a:off x="8868178" y="939433"/>
              <a:ext cx="9092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ytoplasm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428985A-B234-F4A7-34B4-8DDFC7867323}"/>
                </a:ext>
              </a:extLst>
            </p:cNvPr>
            <p:cNvSpPr txBox="1"/>
            <p:nvPr/>
          </p:nvSpPr>
          <p:spPr>
            <a:xfrm rot="19748623">
              <a:off x="9920370" y="983419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Ομάδα 49">
            <a:extLst>
              <a:ext uri="{FF2B5EF4-FFF2-40B4-BE49-F238E27FC236}">
                <a16:creationId xmlns:a16="http://schemas.microsoft.com/office/drawing/2014/main" id="{8A67F5D3-FF2B-19E6-958E-659A5D5C3308}"/>
              </a:ext>
            </a:extLst>
          </p:cNvPr>
          <p:cNvGrpSpPr/>
          <p:nvPr/>
        </p:nvGrpSpPr>
        <p:grpSpPr>
          <a:xfrm>
            <a:off x="387838" y="1230656"/>
            <a:ext cx="4482179" cy="2893151"/>
            <a:chOff x="95607" y="1521878"/>
            <a:chExt cx="4482179" cy="2893151"/>
          </a:xfrm>
        </p:grpSpPr>
        <p:pic>
          <p:nvPicPr>
            <p:cNvPr id="34" name="Εικόνα 33" descr="Εικόνα που περιέχει στιγμιότυπο οθόνης, λευκό, κείμενο, σχεδίαση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1531ED3A-7A69-8181-D8AD-C96165DAB0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3" t="43851"/>
            <a:stretch/>
          </p:blipFill>
          <p:spPr>
            <a:xfrm>
              <a:off x="1049959" y="1857926"/>
              <a:ext cx="1929600" cy="759494"/>
            </a:xfrm>
            <a:prstGeom prst="rect">
              <a:avLst/>
            </a:prstGeom>
          </p:spPr>
        </p:pic>
        <p:pic>
          <p:nvPicPr>
            <p:cNvPr id="36" name="Εικόνα 35" descr="Εικόνα που περιέχει στιγμιότυπο οθόνης&#10;&#10;Περιγραφή που δημιουργήθηκε αυτόματα">
              <a:extLst>
                <a:ext uri="{FF2B5EF4-FFF2-40B4-BE49-F238E27FC236}">
                  <a16:creationId xmlns:a16="http://schemas.microsoft.com/office/drawing/2014/main" id="{6534C968-6A57-6545-352D-D6AC4E5590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91"/>
            <a:stretch/>
          </p:blipFill>
          <p:spPr>
            <a:xfrm>
              <a:off x="1049959" y="2714623"/>
              <a:ext cx="1929600" cy="1700406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4578F12-A5CC-D1FF-2931-A9BE41B33F04}"/>
                </a:ext>
              </a:extLst>
            </p:cNvPr>
            <p:cNvSpPr txBox="1"/>
            <p:nvPr/>
          </p:nvSpPr>
          <p:spPr>
            <a:xfrm rot="19062323">
              <a:off x="1845794" y="15218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0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6A75D1B-A9D8-A2A3-38C1-D4847F1551C2}"/>
                </a:ext>
              </a:extLst>
            </p:cNvPr>
            <p:cNvSpPr txBox="1"/>
            <p:nvPr/>
          </p:nvSpPr>
          <p:spPr>
            <a:xfrm rot="19062323">
              <a:off x="2673066" y="15218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2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4A2E08A-0704-ABBD-83FB-0F825A06661A}"/>
                </a:ext>
              </a:extLst>
            </p:cNvPr>
            <p:cNvSpPr txBox="1"/>
            <p:nvPr/>
          </p:nvSpPr>
          <p:spPr>
            <a:xfrm>
              <a:off x="95607" y="2151130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10 - Ευθύγραμμο βέλος σύνδεσης">
              <a:extLst>
                <a:ext uri="{FF2B5EF4-FFF2-40B4-BE49-F238E27FC236}">
                  <a16:creationId xmlns:a16="http://schemas.microsoft.com/office/drawing/2014/main" id="{BF98EB3A-9805-2202-969B-B24C15FFC9D7}"/>
                </a:ext>
              </a:extLst>
            </p:cNvPr>
            <p:cNvCxnSpPr>
              <a:cxnSpLocks/>
            </p:cNvCxnSpPr>
            <p:nvPr/>
          </p:nvCxnSpPr>
          <p:spPr>
            <a:xfrm>
              <a:off x="787240" y="2288810"/>
              <a:ext cx="180000" cy="1639"/>
            </a:xfrm>
            <a:prstGeom prst="straightConnector1">
              <a:avLst/>
            </a:prstGeom>
            <a:ln w="1270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10 - Ευθύγραμμο βέλος σύνδεσης">
              <a:extLst>
                <a:ext uri="{FF2B5EF4-FFF2-40B4-BE49-F238E27FC236}">
                  <a16:creationId xmlns:a16="http://schemas.microsoft.com/office/drawing/2014/main" id="{40198F2F-08E1-6B13-A0BA-B036D4AA01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97669" y="2288810"/>
              <a:ext cx="180000" cy="1639"/>
            </a:xfrm>
            <a:prstGeom prst="straightConnector1">
              <a:avLst/>
            </a:prstGeom>
            <a:ln w="1270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16F9C60-7B39-B53A-7C4A-4C6155C6C474}"/>
                </a:ext>
              </a:extLst>
            </p:cNvPr>
            <p:cNvSpPr txBox="1"/>
            <p:nvPr/>
          </p:nvSpPr>
          <p:spPr>
            <a:xfrm>
              <a:off x="3122131" y="2151130"/>
              <a:ext cx="14556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YFP-ATXN1(Q82) 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43ACF04-9AC3-251F-7E94-0339DF15B23E}"/>
                </a:ext>
              </a:extLst>
            </p:cNvPr>
            <p:cNvSpPr txBox="1"/>
            <p:nvPr/>
          </p:nvSpPr>
          <p:spPr>
            <a:xfrm>
              <a:off x="180566" y="3322452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10 - Ευθύγραμμο βέλος σύνδεσης">
              <a:extLst>
                <a:ext uri="{FF2B5EF4-FFF2-40B4-BE49-F238E27FC236}">
                  <a16:creationId xmlns:a16="http://schemas.microsoft.com/office/drawing/2014/main" id="{21BB0FE5-1BF0-273B-A79D-CFE357D042F3}"/>
                </a:ext>
              </a:extLst>
            </p:cNvPr>
            <p:cNvCxnSpPr>
              <a:cxnSpLocks/>
            </p:cNvCxnSpPr>
            <p:nvPr/>
          </p:nvCxnSpPr>
          <p:spPr>
            <a:xfrm>
              <a:off x="787240" y="3470513"/>
              <a:ext cx="180000" cy="1639"/>
            </a:xfrm>
            <a:prstGeom prst="straightConnector1">
              <a:avLst/>
            </a:prstGeom>
            <a:ln w="1270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10 - Ευθύγραμμο βέλος σύνδεσης">
              <a:extLst>
                <a:ext uri="{FF2B5EF4-FFF2-40B4-BE49-F238E27FC236}">
                  <a16:creationId xmlns:a16="http://schemas.microsoft.com/office/drawing/2014/main" id="{3E2F4860-5BE8-E766-B079-DDF48DD9C2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24064" y="3470513"/>
              <a:ext cx="180000" cy="1639"/>
            </a:xfrm>
            <a:prstGeom prst="straightConnector1">
              <a:avLst/>
            </a:prstGeom>
            <a:ln w="12700">
              <a:headEnd type="none" w="med" len="med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7C67FE58-372E-421B-F10D-6B3DB008D78A}"/>
                </a:ext>
              </a:extLst>
            </p:cNvPr>
            <p:cNvSpPr txBox="1"/>
            <p:nvPr/>
          </p:nvSpPr>
          <p:spPr>
            <a:xfrm>
              <a:off x="3148526" y="3343213"/>
              <a:ext cx="774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APDH 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A0995533-3BA4-E5C0-D4F1-AE331DBEFC10}"/>
              </a:ext>
            </a:extLst>
          </p:cNvPr>
          <p:cNvSpPr txBox="1"/>
          <p:nvPr/>
        </p:nvSpPr>
        <p:spPr>
          <a:xfrm>
            <a:off x="342712" y="9466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928DEFF-6C17-BEB4-E8DF-7F3998BD9F45}"/>
              </a:ext>
            </a:extLst>
          </p:cNvPr>
          <p:cNvSpPr txBox="1"/>
          <p:nvPr/>
        </p:nvSpPr>
        <p:spPr>
          <a:xfrm>
            <a:off x="5920311" y="9466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l-G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3783349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03</Words>
  <Application>Microsoft Office PowerPoint</Application>
  <PresentationFormat>Ευρεία οθόνη</PresentationFormat>
  <Paragraphs>131</Paragraphs>
  <Slides>9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Giannis Gkekas</dc:creator>
  <cp:lastModifiedBy>Giannis Gkekas</cp:lastModifiedBy>
  <cp:revision>2</cp:revision>
  <dcterms:created xsi:type="dcterms:W3CDTF">2023-10-25T10:08:36Z</dcterms:created>
  <dcterms:modified xsi:type="dcterms:W3CDTF">2023-11-15T11:47:36Z</dcterms:modified>
</cp:coreProperties>
</file>